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83" r:id="rId2"/>
    <p:sldId id="278" r:id="rId3"/>
    <p:sldId id="284" r:id="rId4"/>
    <p:sldId id="282" r:id="rId5"/>
    <p:sldId id="275" r:id="rId6"/>
  </p:sldIdLst>
  <p:sldSz cx="7099300" cy="99441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1259275" initials="h" lastIdx="1" clrIdx="0">
    <p:extLst>
      <p:ext uri="{19B8F6BF-5375-455C-9EA6-DF929625EA0E}">
        <p15:presenceInfo xmlns:p15="http://schemas.microsoft.com/office/powerpoint/2012/main" userId="S::h1259275@hkumssa.onmicrosoft.com::90081730-da7e-4aed-9cd5-1768b6893a8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907"/>
    <p:restoredTop sz="86532"/>
  </p:normalViewPr>
  <p:slideViewPr>
    <p:cSldViewPr snapToGrid="0" snapToObjects="1">
      <p:cViewPr>
        <p:scale>
          <a:sx n="118" d="100"/>
          <a:sy n="118" d="100"/>
        </p:scale>
        <p:origin x="1352" y="232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yon/Library/Mobile%20Documents/com~apple~CloudDocs/Postgrad/miRNA%20Project/Expertiments%20for%20HMRF%20Report/Experiments%20for%20HMRF%20Report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re 2 graphs'!$D$13:$D$14</c:f>
                <c:numCache>
                  <c:formatCode>General</c:formatCode>
                  <c:ptCount val="2"/>
                  <c:pt idx="0">
                    <c:v>0.1767789027378954</c:v>
                  </c:pt>
                  <c:pt idx="1">
                    <c:v>0.155889256761977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Figure 2 graphs'!$C$13:$C$14</c:f>
              <c:numCache>
                <c:formatCode>General</c:formatCode>
                <c:ptCount val="2"/>
                <c:pt idx="0">
                  <c:v>1.0100559866666667</c:v>
                </c:pt>
                <c:pt idx="1">
                  <c:v>1.93285931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14-3A45-81ED-BDF85C81C2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2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re 2 graphs'!$D$3:$D$4</c:f>
                <c:numCache>
                  <c:formatCode>General</c:formatCode>
                  <c:ptCount val="2"/>
                  <c:pt idx="0">
                    <c:v>7.9079520766951003E-2</c:v>
                  </c:pt>
                  <c:pt idx="1">
                    <c:v>0.171833243855262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Figure 2 graphs'!$C$3:$C$4</c:f>
              <c:numCache>
                <c:formatCode>General</c:formatCode>
                <c:ptCount val="2"/>
                <c:pt idx="0">
                  <c:v>1.0021409233333334</c:v>
                </c:pt>
                <c:pt idx="1">
                  <c:v>2.0447717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8B-AA4A-B60C-5D8E095694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2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re 2 graphs'!$D$24:$D$25</c:f>
                <c:numCache>
                  <c:formatCode>General</c:formatCode>
                  <c:ptCount val="2"/>
                  <c:pt idx="0">
                    <c:v>0.17520348632196667</c:v>
                  </c:pt>
                  <c:pt idx="1">
                    <c:v>0.20561318865593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Figure 2 graphs'!$C$24:$C$25</c:f>
              <c:numCache>
                <c:formatCode>General</c:formatCode>
                <c:ptCount val="2"/>
                <c:pt idx="0">
                  <c:v>1.0097444766666668</c:v>
                </c:pt>
                <c:pt idx="1">
                  <c:v>1.7058789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26-F14C-B5EF-641020E6C2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re 2 graphs'!$D$36:$D$37</c:f>
                <c:numCache>
                  <c:formatCode>General</c:formatCode>
                  <c:ptCount val="2"/>
                  <c:pt idx="0">
                    <c:v>0.18263606830010337</c:v>
                  </c:pt>
                  <c:pt idx="1">
                    <c:v>0.25672870574458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Figure 2 graphs'!$C$36:$C$37</c:f>
              <c:numCache>
                <c:formatCode>General</c:formatCode>
                <c:ptCount val="2"/>
                <c:pt idx="0">
                  <c:v>1.0110792733333331</c:v>
                </c:pt>
                <c:pt idx="1">
                  <c:v>1.524186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E3-9644-BAD7-B71FDFEB85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368-024A-9F0B-C6DFF700402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368-024A-9F0B-C6DFF7004020}"/>
              </c:ext>
            </c:extLst>
          </c:dPt>
          <c:errBars>
            <c:errBarType val="plus"/>
            <c:errValType val="cust"/>
            <c:noEndCap val="0"/>
            <c:plus>
              <c:numRef>
                <c:f>'Figure 2 graphs'!$D$45:$D$46</c:f>
                <c:numCache>
                  <c:formatCode>General</c:formatCode>
                  <c:ptCount val="2"/>
                  <c:pt idx="0">
                    <c:v>0.19887956737148077</c:v>
                  </c:pt>
                  <c:pt idx="1">
                    <c:v>0.106240567095693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Figure 2 graphs'!$C$45:$C$46</c:f>
              <c:numCache>
                <c:formatCode>General</c:formatCode>
                <c:ptCount val="2"/>
                <c:pt idx="0">
                  <c:v>1.01234958</c:v>
                </c:pt>
                <c:pt idx="1">
                  <c:v>1.11119829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368-024A-9F0B-C6DFF70040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re 2 graphs'!$D$56:$D$57</c:f>
                <c:numCache>
                  <c:formatCode>General</c:formatCode>
                  <c:ptCount val="2"/>
                  <c:pt idx="0">
                    <c:v>0.15291836038796877</c:v>
                  </c:pt>
                  <c:pt idx="1">
                    <c:v>0.167565970285045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Figure 2 graphs'!$C$56:$C$57</c:f>
              <c:numCache>
                <c:formatCode>General</c:formatCode>
                <c:ptCount val="2"/>
                <c:pt idx="0">
                  <c:v>1.0074301233333334</c:v>
                </c:pt>
                <c:pt idx="1">
                  <c:v>0.81467381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9E-774E-839F-2DE3DACFBF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2780 mouse data'!$D$109:$D$110</c:f>
                <c:numCache>
                  <c:formatCode>General</c:formatCode>
                  <c:ptCount val="2"/>
                  <c:pt idx="0">
                    <c:v>16.41268355493639</c:v>
                  </c:pt>
                  <c:pt idx="1">
                    <c:v>2.3057829821300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A2780 mouse data'!$C$109:$C$110</c:f>
              <c:numCache>
                <c:formatCode>General</c:formatCode>
                <c:ptCount val="2"/>
                <c:pt idx="0">
                  <c:v>100</c:v>
                </c:pt>
                <c:pt idx="1">
                  <c:v>47.2826086956521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CA-7541-9076-007326E022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1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2780 mouse data'!$D$118:$D$119</c:f>
                <c:numCache>
                  <c:formatCode>General</c:formatCode>
                  <c:ptCount val="2"/>
                  <c:pt idx="0">
                    <c:v>7.4432292756478695</c:v>
                  </c:pt>
                  <c:pt idx="1">
                    <c:v>7.44322927564785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A2780 mouse data'!$C$118:$C$119</c:f>
              <c:numCache>
                <c:formatCode>General</c:formatCode>
                <c:ptCount val="2"/>
                <c:pt idx="0">
                  <c:v>100</c:v>
                </c:pt>
                <c:pt idx="1">
                  <c:v>57.8947368421052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B7-5E42-B48E-CE7A58B943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1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26414142521878"/>
          <c:y val="0.2088079615048119"/>
          <c:w val="0.84009519005110433"/>
          <c:h val="0.689432779235928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2780 mouse data'!$D$127:$D$128</c:f>
                <c:numCache>
                  <c:formatCode>General</c:formatCode>
                  <c:ptCount val="2"/>
                  <c:pt idx="0">
                    <c:v>17.625291134445618</c:v>
                  </c:pt>
                  <c:pt idx="1">
                    <c:v>8.15892439830634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A2780 mouse data'!$C$127:$C$128</c:f>
              <c:numCache>
                <c:formatCode>General</c:formatCode>
                <c:ptCount val="2"/>
                <c:pt idx="0">
                  <c:v>100</c:v>
                </c:pt>
                <c:pt idx="1">
                  <c:v>51.9230769230769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80-EA4D-AFDF-935221E19E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9289343"/>
        <c:axId val="1888697487"/>
      </c:barChart>
      <c:dateAx>
        <c:axId val="18892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88697487"/>
        <c:crosses val="autoZero"/>
        <c:auto val="0"/>
        <c:lblOffset val="100"/>
        <c:baseTimeUnit val="days"/>
      </c:dateAx>
      <c:valAx>
        <c:axId val="1888697487"/>
        <c:scaling>
          <c:orientation val="minMax"/>
          <c:max val="1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92893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8CD90E-7B5C-AC4B-9DD4-C38258A77CE9}" type="datetimeFigureOut">
              <a:rPr lang="en-US" smtClean="0"/>
              <a:t>5/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A99FD0-A5EC-DD42-B83F-731EF54E6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128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99FD0-A5EC-DD42-B83F-731EF54E6C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0818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99FD0-A5EC-DD42-B83F-731EF54E6C7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3000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99FD0-A5EC-DD42-B83F-731EF54E6C7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49669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99FD0-A5EC-DD42-B83F-731EF54E6C7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23985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99FD0-A5EC-DD42-B83F-731EF54E6C7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3888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2448" y="1627426"/>
            <a:ext cx="6034405" cy="3462020"/>
          </a:xfrm>
        </p:spPr>
        <p:txBody>
          <a:bodyPr anchor="b"/>
          <a:lstStyle>
            <a:lvl1pPr algn="ctr">
              <a:defRPr sz="46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87413" y="5222955"/>
            <a:ext cx="5324475" cy="2400855"/>
          </a:xfrm>
        </p:spPr>
        <p:txBody>
          <a:bodyPr/>
          <a:lstStyle>
            <a:lvl1pPr marL="0" indent="0" algn="ctr">
              <a:buNone/>
              <a:defRPr sz="1863"/>
            </a:lvl1pPr>
            <a:lvl2pPr marL="354970" indent="0" algn="ctr">
              <a:buNone/>
              <a:defRPr sz="1553"/>
            </a:lvl2pPr>
            <a:lvl3pPr marL="709940" indent="0" algn="ctr">
              <a:buNone/>
              <a:defRPr sz="1398"/>
            </a:lvl3pPr>
            <a:lvl4pPr marL="1064910" indent="0" algn="ctr">
              <a:buNone/>
              <a:defRPr sz="1242"/>
            </a:lvl4pPr>
            <a:lvl5pPr marL="1419880" indent="0" algn="ctr">
              <a:buNone/>
              <a:defRPr sz="1242"/>
            </a:lvl5pPr>
            <a:lvl6pPr marL="1774850" indent="0" algn="ctr">
              <a:buNone/>
              <a:defRPr sz="1242"/>
            </a:lvl6pPr>
            <a:lvl7pPr marL="2129820" indent="0" algn="ctr">
              <a:buNone/>
              <a:defRPr sz="1242"/>
            </a:lvl7pPr>
            <a:lvl8pPr marL="2484791" indent="0" algn="ctr">
              <a:buNone/>
              <a:defRPr sz="1242"/>
            </a:lvl8pPr>
            <a:lvl9pPr marL="2839761" indent="0" algn="ctr">
              <a:buNone/>
              <a:defRPr sz="124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553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036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80437" y="529431"/>
            <a:ext cx="1530787" cy="842716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8077" y="529431"/>
            <a:ext cx="4503618" cy="842716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1376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609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380" y="2479122"/>
            <a:ext cx="6123146" cy="4136469"/>
          </a:xfrm>
        </p:spPr>
        <p:txBody>
          <a:bodyPr anchor="b"/>
          <a:lstStyle>
            <a:lvl1pPr>
              <a:defRPr sz="46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80" y="6654724"/>
            <a:ext cx="6123146" cy="2175271"/>
          </a:xfrm>
        </p:spPr>
        <p:txBody>
          <a:bodyPr/>
          <a:lstStyle>
            <a:lvl1pPr marL="0" indent="0">
              <a:buNone/>
              <a:defRPr sz="1863">
                <a:solidFill>
                  <a:schemeClr val="tx1"/>
                </a:solidFill>
              </a:defRPr>
            </a:lvl1pPr>
            <a:lvl2pPr marL="354970" indent="0">
              <a:buNone/>
              <a:defRPr sz="1553">
                <a:solidFill>
                  <a:schemeClr val="tx1">
                    <a:tint val="75000"/>
                  </a:schemeClr>
                </a:solidFill>
              </a:defRPr>
            </a:lvl2pPr>
            <a:lvl3pPr marL="709940" indent="0">
              <a:buNone/>
              <a:defRPr sz="1398">
                <a:solidFill>
                  <a:schemeClr val="tx1">
                    <a:tint val="75000"/>
                  </a:schemeClr>
                </a:solidFill>
              </a:defRPr>
            </a:lvl3pPr>
            <a:lvl4pPr marL="1064910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4pPr>
            <a:lvl5pPr marL="1419880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5pPr>
            <a:lvl6pPr marL="1774850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6pPr>
            <a:lvl7pPr marL="2129820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7pPr>
            <a:lvl8pPr marL="2484791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8pPr>
            <a:lvl9pPr marL="2839761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95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8077" y="2647156"/>
            <a:ext cx="3017203" cy="63094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4020" y="2647156"/>
            <a:ext cx="3017203" cy="63094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084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529434"/>
            <a:ext cx="6123146" cy="192206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002" y="2437687"/>
            <a:ext cx="3003336" cy="119467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9002" y="3632359"/>
            <a:ext cx="3003336" cy="534265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94021" y="2437687"/>
            <a:ext cx="3018127" cy="119467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94021" y="3632359"/>
            <a:ext cx="3018127" cy="534265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446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44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049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940"/>
            <a:ext cx="2289709" cy="232029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18127" y="1431769"/>
            <a:ext cx="3594021" cy="7066756"/>
          </a:xfrm>
        </p:spPr>
        <p:txBody>
          <a:bodyPr/>
          <a:lstStyle>
            <a:lvl1pPr>
              <a:defRPr sz="2484"/>
            </a:lvl1pPr>
            <a:lvl2pPr>
              <a:defRPr sz="2174"/>
            </a:lvl2pPr>
            <a:lvl3pPr>
              <a:defRPr sz="1863"/>
            </a:lvl3pPr>
            <a:lvl4pPr>
              <a:defRPr sz="1553"/>
            </a:lvl4pPr>
            <a:lvl5pPr>
              <a:defRPr sz="1553"/>
            </a:lvl5pPr>
            <a:lvl6pPr>
              <a:defRPr sz="1553"/>
            </a:lvl6pPr>
            <a:lvl7pPr>
              <a:defRPr sz="1553"/>
            </a:lvl7pPr>
            <a:lvl8pPr>
              <a:defRPr sz="1553"/>
            </a:lvl8pPr>
            <a:lvl9pPr>
              <a:defRPr sz="15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3230"/>
            <a:ext cx="2289709" cy="5526803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330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940"/>
            <a:ext cx="2289709" cy="232029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18127" y="1431769"/>
            <a:ext cx="3594021" cy="7066756"/>
          </a:xfrm>
        </p:spPr>
        <p:txBody>
          <a:bodyPr anchor="t"/>
          <a:lstStyle>
            <a:lvl1pPr marL="0" indent="0">
              <a:buNone/>
              <a:defRPr sz="2484"/>
            </a:lvl1pPr>
            <a:lvl2pPr marL="354970" indent="0">
              <a:buNone/>
              <a:defRPr sz="2174"/>
            </a:lvl2pPr>
            <a:lvl3pPr marL="709940" indent="0">
              <a:buNone/>
              <a:defRPr sz="1863"/>
            </a:lvl3pPr>
            <a:lvl4pPr marL="1064910" indent="0">
              <a:buNone/>
              <a:defRPr sz="1553"/>
            </a:lvl4pPr>
            <a:lvl5pPr marL="1419880" indent="0">
              <a:buNone/>
              <a:defRPr sz="1553"/>
            </a:lvl5pPr>
            <a:lvl6pPr marL="1774850" indent="0">
              <a:buNone/>
              <a:defRPr sz="1553"/>
            </a:lvl6pPr>
            <a:lvl7pPr marL="2129820" indent="0">
              <a:buNone/>
              <a:defRPr sz="1553"/>
            </a:lvl7pPr>
            <a:lvl8pPr marL="2484791" indent="0">
              <a:buNone/>
              <a:defRPr sz="1553"/>
            </a:lvl8pPr>
            <a:lvl9pPr marL="2839761" indent="0">
              <a:buNone/>
              <a:defRPr sz="15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3230"/>
            <a:ext cx="2289709" cy="5526803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356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8077" y="529434"/>
            <a:ext cx="6123146" cy="192206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077" y="2647156"/>
            <a:ext cx="6123146" cy="63094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8077" y="9216710"/>
            <a:ext cx="1597343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04FA57-E47D-FC41-A135-2D6CFE4A82D0}" type="datetimeFigureOut">
              <a:rPr lang="en-US" smtClean="0"/>
              <a:t>5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51643" y="9216710"/>
            <a:ext cx="2396014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13880" y="9216710"/>
            <a:ext cx="1597343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48A5D6-D888-9147-AC8B-A70196CB46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169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09940" rtl="0" eaLnBrk="1" latinLnBrk="0" hangingPunct="1">
        <a:lnSpc>
          <a:spcPct val="90000"/>
        </a:lnSpc>
        <a:spcBef>
          <a:spcPct val="0"/>
        </a:spcBef>
        <a:buNone/>
        <a:defRPr sz="34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7485" indent="-177485" algn="l" defTabSz="709940" rtl="0" eaLnBrk="1" latinLnBrk="0" hangingPunct="1">
        <a:lnSpc>
          <a:spcPct val="90000"/>
        </a:lnSpc>
        <a:spcBef>
          <a:spcPts val="776"/>
        </a:spcBef>
        <a:buFont typeface="Arial" panose="020B0604020202020204" pitchFamily="34" charset="0"/>
        <a:buChar char="•"/>
        <a:defRPr sz="2174" kern="1200">
          <a:solidFill>
            <a:schemeClr val="tx1"/>
          </a:solidFill>
          <a:latin typeface="+mn-lt"/>
          <a:ea typeface="+mn-ea"/>
          <a:cs typeface="+mn-cs"/>
        </a:defRPr>
      </a:lvl1pPr>
      <a:lvl2pPr marL="53245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863" kern="1200">
          <a:solidFill>
            <a:schemeClr val="tx1"/>
          </a:solidFill>
          <a:latin typeface="+mn-lt"/>
          <a:ea typeface="+mn-ea"/>
          <a:cs typeface="+mn-cs"/>
        </a:defRPr>
      </a:lvl2pPr>
      <a:lvl3pPr marL="88742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553" kern="1200">
          <a:solidFill>
            <a:schemeClr val="tx1"/>
          </a:solidFill>
          <a:latin typeface="+mn-lt"/>
          <a:ea typeface="+mn-ea"/>
          <a:cs typeface="+mn-cs"/>
        </a:defRPr>
      </a:lvl3pPr>
      <a:lvl4pPr marL="124239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59736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95233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30730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66227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301724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1pPr>
      <a:lvl2pPr marL="35497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2pPr>
      <a:lvl3pPr marL="70994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3pPr>
      <a:lvl4pPr marL="106491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41988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77485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12982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48479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283976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emf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13" Type="http://schemas.openxmlformats.org/officeDocument/2006/relationships/image" Target="../media/image24.jpeg"/><Relationship Id="rId18" Type="http://schemas.openxmlformats.org/officeDocument/2006/relationships/image" Target="../media/image27.jpeg"/><Relationship Id="rId3" Type="http://schemas.openxmlformats.org/officeDocument/2006/relationships/chart" Target="../charts/chart7.xml"/><Relationship Id="rId21" Type="http://schemas.openxmlformats.org/officeDocument/2006/relationships/image" Target="../media/image30.jpeg"/><Relationship Id="rId7" Type="http://schemas.openxmlformats.org/officeDocument/2006/relationships/image" Target="../media/image18.jpeg"/><Relationship Id="rId12" Type="http://schemas.openxmlformats.org/officeDocument/2006/relationships/image" Target="../media/image23.jpeg"/><Relationship Id="rId17" Type="http://schemas.openxmlformats.org/officeDocument/2006/relationships/chart" Target="../charts/chart9.xml"/><Relationship Id="rId2" Type="http://schemas.openxmlformats.org/officeDocument/2006/relationships/notesSlide" Target="../notesSlides/notesSlide5.xml"/><Relationship Id="rId16" Type="http://schemas.openxmlformats.org/officeDocument/2006/relationships/chart" Target="../charts/chart8.xml"/><Relationship Id="rId20" Type="http://schemas.openxmlformats.org/officeDocument/2006/relationships/image" Target="../media/image2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eg"/><Relationship Id="rId11" Type="http://schemas.openxmlformats.org/officeDocument/2006/relationships/image" Target="../media/image22.jpeg"/><Relationship Id="rId24" Type="http://schemas.openxmlformats.org/officeDocument/2006/relationships/image" Target="../media/image33.emf"/><Relationship Id="rId5" Type="http://schemas.openxmlformats.org/officeDocument/2006/relationships/image" Target="../media/image16.jpeg"/><Relationship Id="rId15" Type="http://schemas.openxmlformats.org/officeDocument/2006/relationships/image" Target="../media/image26.jpeg"/><Relationship Id="rId23" Type="http://schemas.openxmlformats.org/officeDocument/2006/relationships/image" Target="../media/image32.emf"/><Relationship Id="rId10" Type="http://schemas.openxmlformats.org/officeDocument/2006/relationships/image" Target="../media/image21.jpeg"/><Relationship Id="rId19" Type="http://schemas.openxmlformats.org/officeDocument/2006/relationships/image" Target="../media/image28.jpeg"/><Relationship Id="rId4" Type="http://schemas.openxmlformats.org/officeDocument/2006/relationships/image" Target="../media/image15.jpeg"/><Relationship Id="rId9" Type="http://schemas.openxmlformats.org/officeDocument/2006/relationships/image" Target="../media/image20.jpeg"/><Relationship Id="rId14" Type="http://schemas.openxmlformats.org/officeDocument/2006/relationships/image" Target="../media/image25.jpeg"/><Relationship Id="rId22" Type="http://schemas.openxmlformats.org/officeDocument/2006/relationships/image" Target="../media/image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0">
            <a:extLst>
              <a:ext uri="{FF2B5EF4-FFF2-40B4-BE49-F238E27FC236}">
                <a16:creationId xmlns:a16="http://schemas.microsoft.com/office/drawing/2014/main" id="{0BB7D617-AAA4-FE43-8B52-8BB13ACCC5A6}"/>
              </a:ext>
            </a:extLst>
          </p:cNvPr>
          <p:cNvSpPr/>
          <p:nvPr/>
        </p:nvSpPr>
        <p:spPr>
          <a:xfrm>
            <a:off x="-51390" y="3612556"/>
            <a:ext cx="720208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. miR-199a-3p is transcriptionally regulated through PI3K/Akt pathway. (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) Expression of miR-199a-3p and miR-199a-1 upon treatment with PI3K inhibitor LY294002 and Akt siRNA. (B) Expression of miR-199a-3p and miR-199a-1 upon treatment with IKK inhibitor BAY11-7082. (C) Expression of miR-199a-3p upon treatment with MEK inhibitor PD98059.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Bar graph values are mean ± SD, n=3. T-test. *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5, **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05, ***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005.</a:t>
            </a:r>
            <a:endParaRPr lang="en-US" sz="1000" b="1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9A739E9-F630-754B-9108-8FF6D270E01A}"/>
              </a:ext>
            </a:extLst>
          </p:cNvPr>
          <p:cNvSpPr txBox="1"/>
          <p:nvPr/>
        </p:nvSpPr>
        <p:spPr>
          <a:xfrm>
            <a:off x="84650" y="-2777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A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82F641C2-5E7C-C94D-900F-C270238BB6BE}"/>
              </a:ext>
            </a:extLst>
          </p:cNvPr>
          <p:cNvGrpSpPr/>
          <p:nvPr/>
        </p:nvGrpSpPr>
        <p:grpSpPr>
          <a:xfrm>
            <a:off x="2626429" y="-135173"/>
            <a:ext cx="1674145" cy="2408294"/>
            <a:chOff x="2406109" y="151930"/>
            <a:chExt cx="1674145" cy="2408294"/>
          </a:xfrm>
        </p:grpSpPr>
        <p:graphicFrame>
          <p:nvGraphicFramePr>
            <p:cNvPr id="44" name="Chart 43">
              <a:extLst>
                <a:ext uri="{FF2B5EF4-FFF2-40B4-BE49-F238E27FC236}">
                  <a16:creationId xmlns:a16="http://schemas.microsoft.com/office/drawing/2014/main" id="{4A5EFB1B-E7F7-EA45-8411-2E555212A51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797388" y="151930"/>
            <a:ext cx="1282866" cy="14331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75686866-086F-8D4F-8E5F-FEE1D2E102A4}"/>
                </a:ext>
              </a:extLst>
            </p:cNvPr>
            <p:cNvSpPr/>
            <p:nvPr/>
          </p:nvSpPr>
          <p:spPr>
            <a:xfrm rot="16200000">
              <a:off x="1861409" y="718438"/>
              <a:ext cx="148951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of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1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E98CF2D-83EC-D040-9DC5-6BF50D17F9A8}"/>
                </a:ext>
              </a:extLst>
            </p:cNvPr>
            <p:cNvSpPr txBox="1"/>
            <p:nvPr/>
          </p:nvSpPr>
          <p:spPr>
            <a:xfrm rot="18767311">
              <a:off x="2483116" y="1723068"/>
              <a:ext cx="1105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B903FEB-B7EE-3F43-A38A-770AAA357304}"/>
                </a:ext>
              </a:extLst>
            </p:cNvPr>
            <p:cNvSpPr txBox="1"/>
            <p:nvPr/>
          </p:nvSpPr>
          <p:spPr>
            <a:xfrm rot="18767311">
              <a:off x="2834049" y="1791314"/>
              <a:ext cx="1291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LY294002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6">
              <a:extLst>
                <a:ext uri="{FF2B5EF4-FFF2-40B4-BE49-F238E27FC236}">
                  <a16:creationId xmlns:a16="http://schemas.microsoft.com/office/drawing/2014/main" id="{4F668125-7FEC-FB4B-8996-F670B807AA7A}"/>
                </a:ext>
              </a:extLst>
            </p:cNvPr>
            <p:cNvSpPr txBox="1"/>
            <p:nvPr/>
          </p:nvSpPr>
          <p:spPr>
            <a:xfrm>
              <a:off x="3610968" y="442758"/>
              <a:ext cx="463461" cy="261348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/>
                <a:t>**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E8611E87-0B09-F044-AB04-74B1B12B81B2}"/>
              </a:ext>
            </a:extLst>
          </p:cNvPr>
          <p:cNvGrpSpPr/>
          <p:nvPr/>
        </p:nvGrpSpPr>
        <p:grpSpPr>
          <a:xfrm>
            <a:off x="551974" y="-141627"/>
            <a:ext cx="1658852" cy="2411559"/>
            <a:chOff x="498187" y="153096"/>
            <a:chExt cx="1658852" cy="2411559"/>
          </a:xfrm>
        </p:grpSpPr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4FE907DA-7C43-AF46-8915-243CBDF0A7E1}"/>
                </a:ext>
              </a:extLst>
            </p:cNvPr>
            <p:cNvGrpSpPr/>
            <p:nvPr/>
          </p:nvGrpSpPr>
          <p:grpSpPr>
            <a:xfrm>
              <a:off x="498187" y="153096"/>
              <a:ext cx="1658852" cy="2411559"/>
              <a:chOff x="498187" y="123360"/>
              <a:chExt cx="1658852" cy="2411559"/>
            </a:xfrm>
          </p:grpSpPr>
          <p:graphicFrame>
            <p:nvGraphicFramePr>
              <p:cNvPr id="52" name="Chart 51">
                <a:extLst>
                  <a:ext uri="{FF2B5EF4-FFF2-40B4-BE49-F238E27FC236}">
                    <a16:creationId xmlns:a16="http://schemas.microsoft.com/office/drawing/2014/main" id="{3C3D4153-0CB6-5C41-A506-45C1EC73DE8E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874173" y="123360"/>
              <a:ext cx="1282866" cy="14331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7AE69B63-D35F-D84F-AD44-001E42254303}"/>
                  </a:ext>
                </a:extLst>
              </p:cNvPr>
              <p:cNvSpPr/>
              <p:nvPr/>
            </p:nvSpPr>
            <p:spPr>
              <a:xfrm rot="16200000">
                <a:off x="-46513" y="693133"/>
                <a:ext cx="1489510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defRPr sz="700" b="0" i="0" u="none" strike="noStrike" kern="1200" baseline="0">
                    <a:solidFill>
                      <a:prstClr val="black"/>
                    </a:solidFill>
                    <a:latin typeface="Arial Unicode MS" panose="020B0604020202020204" pitchFamily="34" charset="-120"/>
                    <a:ea typeface="Arial Unicode MS" panose="020B0604020202020204" pitchFamily="34" charset="-120"/>
                    <a:cs typeface="Arial Unicode MS" panose="020B0604020202020204" pitchFamily="34" charset="-120"/>
                  </a:defRPr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of </a:t>
                </a:r>
              </a:p>
              <a:p>
                <a:pPr algn="ctr">
                  <a:defRPr sz="700" b="0" i="0" u="none" strike="noStrike" kern="1200" baseline="0">
                    <a:solidFill>
                      <a:prstClr val="black"/>
                    </a:solidFill>
                    <a:latin typeface="Arial Unicode MS" panose="020B0604020202020204" pitchFamily="34" charset="-120"/>
                    <a:ea typeface="Arial Unicode MS" panose="020B0604020202020204" pitchFamily="34" charset="-120"/>
                    <a:cs typeface="Arial Unicode MS" panose="020B0604020202020204" pitchFamily="34" charset="-120"/>
                  </a:defRPr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199a-3p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4020BDE-5DB4-5E45-8FEF-05731CCB982D}"/>
                  </a:ext>
                </a:extLst>
              </p:cNvPr>
              <p:cNvSpPr txBox="1"/>
              <p:nvPr/>
            </p:nvSpPr>
            <p:spPr>
              <a:xfrm rot="18767311">
                <a:off x="575194" y="1697763"/>
                <a:ext cx="11056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1165F59-D310-7646-9DEA-3B7516C862DE}"/>
                  </a:ext>
                </a:extLst>
              </p:cNvPr>
              <p:cNvSpPr txBox="1"/>
              <p:nvPr/>
            </p:nvSpPr>
            <p:spPr>
              <a:xfrm rot="18767311">
                <a:off x="926127" y="1766009"/>
                <a:ext cx="12915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Y294002</a:t>
                </a:r>
                <a:endPara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1" name="TextBox 6">
              <a:extLst>
                <a:ext uri="{FF2B5EF4-FFF2-40B4-BE49-F238E27FC236}">
                  <a16:creationId xmlns:a16="http://schemas.microsoft.com/office/drawing/2014/main" id="{6F4794FB-471B-7447-B65E-CBBD7C8270F7}"/>
                </a:ext>
              </a:extLst>
            </p:cNvPr>
            <p:cNvSpPr txBox="1"/>
            <p:nvPr/>
          </p:nvSpPr>
          <p:spPr>
            <a:xfrm>
              <a:off x="1682003" y="377109"/>
              <a:ext cx="463461" cy="261348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/>
                <a:t>***</a:t>
              </a:r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EB5CA889-B945-5B4E-9A66-0EB60B14493B}"/>
              </a:ext>
            </a:extLst>
          </p:cNvPr>
          <p:cNvGrpSpPr/>
          <p:nvPr/>
        </p:nvGrpSpPr>
        <p:grpSpPr>
          <a:xfrm>
            <a:off x="4716177" y="-135074"/>
            <a:ext cx="1667876" cy="2392366"/>
            <a:chOff x="4098853" y="182509"/>
            <a:chExt cx="1667876" cy="2392366"/>
          </a:xfrm>
        </p:grpSpPr>
        <p:graphicFrame>
          <p:nvGraphicFramePr>
            <p:cNvPr id="57" name="Chart 56">
              <a:extLst>
                <a:ext uri="{FF2B5EF4-FFF2-40B4-BE49-F238E27FC236}">
                  <a16:creationId xmlns:a16="http://schemas.microsoft.com/office/drawing/2014/main" id="{8D84C701-CE52-074B-8B50-F27FDCD9127A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483863" y="182509"/>
            <a:ext cx="1282866" cy="14331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66A3FAA5-1622-CD48-A87E-6E8DCB68AA03}"/>
                </a:ext>
              </a:extLst>
            </p:cNvPr>
            <p:cNvSpPr/>
            <p:nvPr/>
          </p:nvSpPr>
          <p:spPr>
            <a:xfrm rot="16200000">
              <a:off x="3554153" y="733089"/>
              <a:ext cx="148951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of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EA8D4F20-B99E-194C-A46C-03C645270CBC}"/>
                </a:ext>
              </a:extLst>
            </p:cNvPr>
            <p:cNvSpPr txBox="1"/>
            <p:nvPr/>
          </p:nvSpPr>
          <p:spPr>
            <a:xfrm rot="18767311">
              <a:off x="4175860" y="1737719"/>
              <a:ext cx="1105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S siRN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73217812-92D6-4249-86C4-CB5FD1A5A3C1}"/>
                </a:ext>
              </a:extLst>
            </p:cNvPr>
            <p:cNvSpPr txBox="1"/>
            <p:nvPr/>
          </p:nvSpPr>
          <p:spPr>
            <a:xfrm rot="18767311">
              <a:off x="4526793" y="1805965"/>
              <a:ext cx="1291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kt siRNA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">
              <a:extLst>
                <a:ext uri="{FF2B5EF4-FFF2-40B4-BE49-F238E27FC236}">
                  <a16:creationId xmlns:a16="http://schemas.microsoft.com/office/drawing/2014/main" id="{857144F0-F8BC-0444-8C0F-7A86D0D87EB0}"/>
                </a:ext>
              </a:extLst>
            </p:cNvPr>
            <p:cNvSpPr txBox="1"/>
            <p:nvPr/>
          </p:nvSpPr>
          <p:spPr>
            <a:xfrm>
              <a:off x="5291693" y="361841"/>
              <a:ext cx="463461" cy="261348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/>
                <a:t>*</a:t>
              </a:r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DFC449E0-CF30-5541-9799-098D8A8727F5}"/>
              </a:ext>
            </a:extLst>
          </p:cNvPr>
          <p:cNvGrpSpPr/>
          <p:nvPr/>
        </p:nvGrpSpPr>
        <p:grpSpPr>
          <a:xfrm>
            <a:off x="550288" y="1632245"/>
            <a:ext cx="1658072" cy="2581016"/>
            <a:chOff x="631007" y="2720453"/>
            <a:chExt cx="1658072" cy="2581016"/>
          </a:xfrm>
        </p:grpSpPr>
        <p:graphicFrame>
          <p:nvGraphicFramePr>
            <p:cNvPr id="63" name="Chart 62">
              <a:extLst>
                <a:ext uri="{FF2B5EF4-FFF2-40B4-BE49-F238E27FC236}">
                  <a16:creationId xmlns:a16="http://schemas.microsoft.com/office/drawing/2014/main" id="{391E6F3C-DA2F-E44B-93B6-041C2E31F36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006213" y="2720453"/>
            <a:ext cx="1282866" cy="14331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D75EC97F-79B0-384A-8FEC-215D25B036AC}"/>
                </a:ext>
              </a:extLst>
            </p:cNvPr>
            <p:cNvSpPr/>
            <p:nvPr/>
          </p:nvSpPr>
          <p:spPr>
            <a:xfrm rot="16200000">
              <a:off x="86307" y="3291409"/>
              <a:ext cx="148951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of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804295D-1C3D-234F-98AE-46D7B5A8942D}"/>
                </a:ext>
              </a:extLst>
            </p:cNvPr>
            <p:cNvSpPr txBox="1"/>
            <p:nvPr/>
          </p:nvSpPr>
          <p:spPr>
            <a:xfrm rot="18767311">
              <a:off x="708014" y="4296039"/>
              <a:ext cx="1105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6012EF0D-F9CE-E247-9741-C60E4482FA5A}"/>
                </a:ext>
              </a:extLst>
            </p:cNvPr>
            <p:cNvSpPr txBox="1"/>
            <p:nvPr/>
          </p:nvSpPr>
          <p:spPr>
            <a:xfrm rot="18767311">
              <a:off x="864727" y="4417487"/>
              <a:ext cx="1521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BAY11-7082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">
              <a:extLst>
                <a:ext uri="{FF2B5EF4-FFF2-40B4-BE49-F238E27FC236}">
                  <a16:creationId xmlns:a16="http://schemas.microsoft.com/office/drawing/2014/main" id="{5D59C34B-1DF2-1041-B06F-C450502E6D4E}"/>
                </a:ext>
              </a:extLst>
            </p:cNvPr>
            <p:cNvSpPr txBox="1"/>
            <p:nvPr/>
          </p:nvSpPr>
          <p:spPr>
            <a:xfrm>
              <a:off x="1810229" y="2937548"/>
              <a:ext cx="463461" cy="261348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/>
                <a:t>*</a:t>
              </a: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416566F0-83BD-5845-9036-86150210DA81}"/>
              </a:ext>
            </a:extLst>
          </p:cNvPr>
          <p:cNvSpPr txBox="1"/>
          <p:nvPr/>
        </p:nvSpPr>
        <p:spPr>
          <a:xfrm>
            <a:off x="84650" y="169768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B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5EED5AAD-8CF0-804B-9F80-C46AE2B80DB5}"/>
              </a:ext>
            </a:extLst>
          </p:cNvPr>
          <p:cNvGrpSpPr/>
          <p:nvPr/>
        </p:nvGrpSpPr>
        <p:grpSpPr>
          <a:xfrm>
            <a:off x="2632134" y="1629014"/>
            <a:ext cx="1657960" cy="2514800"/>
            <a:chOff x="2749746" y="2740082"/>
            <a:chExt cx="1657960" cy="2514800"/>
          </a:xfrm>
        </p:grpSpPr>
        <p:graphicFrame>
          <p:nvGraphicFramePr>
            <p:cNvPr id="70" name="Chart 69">
              <a:extLst>
                <a:ext uri="{FF2B5EF4-FFF2-40B4-BE49-F238E27FC236}">
                  <a16:creationId xmlns:a16="http://schemas.microsoft.com/office/drawing/2014/main" id="{C9BA83D6-6656-5746-8A6E-E3187A4F77B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124840" y="2740082"/>
            <a:ext cx="1282866" cy="14331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F6300454-7596-8B48-B5FD-0DD3F383D97E}"/>
                </a:ext>
              </a:extLst>
            </p:cNvPr>
            <p:cNvSpPr/>
            <p:nvPr/>
          </p:nvSpPr>
          <p:spPr>
            <a:xfrm rot="16200000">
              <a:off x="2205046" y="3306024"/>
              <a:ext cx="148951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of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1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E3BD4E33-62B7-F14D-A40E-F6B22C7ABD66}"/>
                </a:ext>
              </a:extLst>
            </p:cNvPr>
            <p:cNvSpPr txBox="1"/>
            <p:nvPr/>
          </p:nvSpPr>
          <p:spPr>
            <a:xfrm rot="18767311">
              <a:off x="2826753" y="4310654"/>
              <a:ext cx="1105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9F56147-C2C0-9041-902E-5A3B36A79A48}"/>
                </a:ext>
              </a:extLst>
            </p:cNvPr>
            <p:cNvSpPr txBox="1"/>
            <p:nvPr/>
          </p:nvSpPr>
          <p:spPr>
            <a:xfrm rot="18767311">
              <a:off x="3036054" y="4411227"/>
              <a:ext cx="14410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BAY11-7082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0AC516B8-1140-0947-A832-82A6FAE5C99A}"/>
              </a:ext>
            </a:extLst>
          </p:cNvPr>
          <p:cNvGrpSpPr/>
          <p:nvPr/>
        </p:nvGrpSpPr>
        <p:grpSpPr>
          <a:xfrm>
            <a:off x="4713867" y="1658501"/>
            <a:ext cx="1670835" cy="2528031"/>
            <a:chOff x="4782447" y="2746709"/>
            <a:chExt cx="1670835" cy="2528031"/>
          </a:xfrm>
        </p:grpSpPr>
        <p:graphicFrame>
          <p:nvGraphicFramePr>
            <p:cNvPr id="75" name="Chart 74">
              <a:extLst>
                <a:ext uri="{FF2B5EF4-FFF2-40B4-BE49-F238E27FC236}">
                  <a16:creationId xmlns:a16="http://schemas.microsoft.com/office/drawing/2014/main" id="{7BCF2882-6BEC-8341-A281-7AC33D6A354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170416" y="2746709"/>
            <a:ext cx="1282866" cy="14331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A340ABB4-9C63-3B4F-B15B-E1511ECE682C}"/>
                </a:ext>
              </a:extLst>
            </p:cNvPr>
            <p:cNvSpPr/>
            <p:nvPr/>
          </p:nvSpPr>
          <p:spPr>
            <a:xfrm rot="16200000">
              <a:off x="4237747" y="3306024"/>
              <a:ext cx="148951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of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1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AB56F17-A8BA-1D4C-842C-5AFB0262D8A0}"/>
                </a:ext>
              </a:extLst>
            </p:cNvPr>
            <p:cNvSpPr txBox="1"/>
            <p:nvPr/>
          </p:nvSpPr>
          <p:spPr>
            <a:xfrm rot="18767311">
              <a:off x="4859454" y="4310654"/>
              <a:ext cx="1105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0EF61F90-6B85-C945-B829-013367220625}"/>
                </a:ext>
              </a:extLst>
            </p:cNvPr>
            <p:cNvSpPr txBox="1"/>
            <p:nvPr/>
          </p:nvSpPr>
          <p:spPr>
            <a:xfrm rot="18767311">
              <a:off x="5089440" y="4435285"/>
              <a:ext cx="14326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98059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357873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8FA74B2-694E-C942-93B3-EA39E94D4F2F}"/>
              </a:ext>
            </a:extLst>
          </p:cNvPr>
          <p:cNvSpPr/>
          <p:nvPr/>
        </p:nvSpPr>
        <p:spPr>
          <a:xfrm>
            <a:off x="0" y="4993319"/>
            <a:ext cx="720208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1. List of top upregulated genes under shear stress from whole cell RNA sequencing sorted by p-value  </a:t>
            </a:r>
          </a:p>
        </p:txBody>
      </p:sp>
      <p:graphicFrame>
        <p:nvGraphicFramePr>
          <p:cNvPr id="6" name="Table 2">
            <a:extLst>
              <a:ext uri="{FF2B5EF4-FFF2-40B4-BE49-F238E27FC236}">
                <a16:creationId xmlns:a16="http://schemas.microsoft.com/office/drawing/2014/main" id="{A856507B-9EDB-3C4E-4CD9-95C8803687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578275"/>
              </p:ext>
            </p:extLst>
          </p:nvPr>
        </p:nvGraphicFramePr>
        <p:xfrm>
          <a:off x="93037" y="90491"/>
          <a:ext cx="6913226" cy="47853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834714">
                  <a:extLst>
                    <a:ext uri="{9D8B030D-6E8A-4147-A177-3AD203B41FA5}">
                      <a16:colId xmlns:a16="http://schemas.microsoft.com/office/drawing/2014/main" val="1659654904"/>
                    </a:ext>
                  </a:extLst>
                </a:gridCol>
                <a:gridCol w="867951">
                  <a:extLst>
                    <a:ext uri="{9D8B030D-6E8A-4147-A177-3AD203B41FA5}">
                      <a16:colId xmlns:a16="http://schemas.microsoft.com/office/drawing/2014/main" val="3231610843"/>
                    </a:ext>
                  </a:extLst>
                </a:gridCol>
                <a:gridCol w="1050324">
                  <a:extLst>
                    <a:ext uri="{9D8B030D-6E8A-4147-A177-3AD203B41FA5}">
                      <a16:colId xmlns:a16="http://schemas.microsoft.com/office/drawing/2014/main" val="789025696"/>
                    </a:ext>
                  </a:extLst>
                </a:gridCol>
                <a:gridCol w="1123554">
                  <a:extLst>
                    <a:ext uri="{9D8B030D-6E8A-4147-A177-3AD203B41FA5}">
                      <a16:colId xmlns:a16="http://schemas.microsoft.com/office/drawing/2014/main" val="853336057"/>
                    </a:ext>
                  </a:extLst>
                </a:gridCol>
                <a:gridCol w="993380">
                  <a:extLst>
                    <a:ext uri="{9D8B030D-6E8A-4147-A177-3AD203B41FA5}">
                      <a16:colId xmlns:a16="http://schemas.microsoft.com/office/drawing/2014/main" val="683528864"/>
                    </a:ext>
                  </a:extLst>
                </a:gridCol>
                <a:gridCol w="2043303">
                  <a:extLst>
                    <a:ext uri="{9D8B030D-6E8A-4147-A177-3AD203B41FA5}">
                      <a16:colId xmlns:a16="http://schemas.microsoft.com/office/drawing/2014/main" val="675169255"/>
                    </a:ext>
                  </a:extLst>
                </a:gridCol>
              </a:tblGrid>
              <a:tr h="39319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c-Expres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dyne/cm</a:t>
                      </a:r>
                      <a:r>
                        <a:rPr lang="en-US" sz="10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Expression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US" sz="10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bo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802888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1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7059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2E-1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PTL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6029609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6189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4E-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DHGC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3986279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5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3602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1E-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DH3A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341304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83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66248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2E-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F2H2C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6761950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69412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E-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1A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870530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5340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686500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7E-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AIP8L2-SCNM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2065038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868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65784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4F-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CL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60876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5268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2850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7E-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17-C180rf3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1432938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14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09453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2E-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KRD20A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371425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0057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E-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BP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984853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8622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1E-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B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19291539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004397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E-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0302717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317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761244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E-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2T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1117584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7652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1E-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BP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8451784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5061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22367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1E-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FX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9117261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31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8496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E-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099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LGA8K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753864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710559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FC993AE9-17EA-A843-8464-0E465D32AA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5447973"/>
              </p:ext>
            </p:extLst>
          </p:nvPr>
        </p:nvGraphicFramePr>
        <p:xfrm>
          <a:off x="97007" y="206902"/>
          <a:ext cx="6905286" cy="552069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64887">
                  <a:extLst>
                    <a:ext uri="{9D8B030D-6E8A-4147-A177-3AD203B41FA5}">
                      <a16:colId xmlns:a16="http://schemas.microsoft.com/office/drawing/2014/main" val="1659654904"/>
                    </a:ext>
                  </a:extLst>
                </a:gridCol>
                <a:gridCol w="692834">
                  <a:extLst>
                    <a:ext uri="{9D8B030D-6E8A-4147-A177-3AD203B41FA5}">
                      <a16:colId xmlns:a16="http://schemas.microsoft.com/office/drawing/2014/main" val="3231610843"/>
                    </a:ext>
                  </a:extLst>
                </a:gridCol>
                <a:gridCol w="953085">
                  <a:extLst>
                    <a:ext uri="{9D8B030D-6E8A-4147-A177-3AD203B41FA5}">
                      <a16:colId xmlns:a16="http://schemas.microsoft.com/office/drawing/2014/main" val="789025696"/>
                    </a:ext>
                  </a:extLst>
                </a:gridCol>
                <a:gridCol w="892455">
                  <a:extLst>
                    <a:ext uri="{9D8B030D-6E8A-4147-A177-3AD203B41FA5}">
                      <a16:colId xmlns:a16="http://schemas.microsoft.com/office/drawing/2014/main" val="853336057"/>
                    </a:ext>
                  </a:extLst>
                </a:gridCol>
                <a:gridCol w="2902025">
                  <a:extLst>
                    <a:ext uri="{9D8B030D-6E8A-4147-A177-3AD203B41FA5}">
                      <a16:colId xmlns:a16="http://schemas.microsoft.com/office/drawing/2014/main" val="68352886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ds Rati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bined Sc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80288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eomycin DB00290 mouse GSE25640 sample 31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7E-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31369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792967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BP1;TNNC1;FMO3;SLC7A10;CIDEC;ASGR1;GNMT;SELENBP1;ALDH3A1;CSRP3;ACOXL;OBP2A;CYP1A1;CYP2E1;HAMP;SLC38A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602960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 DB00515 human GSE47856 sample 315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8E-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42861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006481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GT1A10;HIST1H2BM;G6PD;HIST1H3J;HIST1H4K;HIST1H2AK;HIST1H2AJ;HIST2H2AB;C1QTNF9B;EFNB2;ADAMTS15;TMSB15A;GJB7;HIST2H3D;HIST1H2BB;HIST1H1B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398627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 DB00515 human GSE47856 sample 31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E-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08749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327253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1H2AM;HIST1H2BM;ITIH2;HIST1H3J;HIST1H4K;HIST1H2AK;HIST1H2AJ;HIST2H2AB;ANXA10;PTHLH;GPC1;HIST1H2AE;HIST1H2BB;EPHA3;HIST1H4E;HIST1H1B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34130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amphetamine 10836 mouse GSE30305 sample 26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2E-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48673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491238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BP1;ITIH2;TMEM200A;TNNC1;BGN;ASGR1;ALDH3A1;THBD;GJB2;TMIE;SLC25A18;KRT14;CCDC3;PTGDS;STK32B;CBLN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676195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 DB00515 human GSE47856 sample 31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9E-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67612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913555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1H2AM;HIST1H2BM;HIST1H3J;HIST1H4K;HIST1H2AK;HIST1H2AJ;HIST1H2AE;HIST2H2AB;HIST2H3D;HIST1H4E;HIST1H1B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87053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CKEL 935 human GSE6281 sample 34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033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714595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677870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F177;VIPR1;CLIC3;C2ORF40;DLX5;ELOVL3;SHISA2;ASPRV1;CORO2B;CYP3A5;ENDOU;OLFML3;CYP1A1;FXYD6;ACSBG1;PTGDS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206503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 DB00515 human GSE47856 sample 315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1428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9131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779965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1H2AM;HIST1H2BM;HIST1H3J;HIST1H4K;KLHL14;DLX5;AKR1C1;HIST1H2AK;HIST2H2AB;AKR1C2;ORM2;CST1;COL1A2;FAM110B;HIST1H2AE;CYP1B1;HIST2H3D;HIST1H1B;SLC38A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6087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 DB00515 human GSE47856 sample 31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4815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1914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11909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1H2BM;HIST1H3J;AKR1C1;HIST1H2AK;HIST1H2AJ;HIST2H2AB;OR2T8;CCNA1;HIST1H2AE;HIST2H3D;HIST1H4E;HIST1H1B;SLC38A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143293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platin DB00958 human GSE49577 sample 31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062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51322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7685927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GT1A10;C2ORF40;HIST1H4K;S100A2;WDR86;HBA2;ANXA10;SELENBP1;ALDH3A1;EIF3CL;HMGCS2;PTGDS;HIST1H1B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37142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platin DB00515 human GSE47856 sample 31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749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86894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92277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T2;UGT1A10;HIST1H2BM;HIST1H3J;HIST1H4K;HIST1H2AK;HIST1H2AJ;HIST2H2AB;TAS2R19;HIST1H2AE;HIST2H3D;HIST1H2BB;HIST1H1B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9848538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EDF50055-BC4C-AA9C-55B9-2F9C3181B25A}"/>
              </a:ext>
            </a:extLst>
          </p:cNvPr>
          <p:cNvSpPr/>
          <p:nvPr/>
        </p:nvSpPr>
        <p:spPr>
          <a:xfrm>
            <a:off x="0" y="5886701"/>
            <a:ext cx="70993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2. P-value, Odds Ratio, Combined Score, and Genes for pathways upregulated under shear stress from whole cell RNA sequencing </a:t>
            </a:r>
          </a:p>
          <a:p>
            <a:pPr algn="just"/>
            <a:endParaRPr lang="en-US" sz="10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76684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8FA74B2-694E-C942-93B3-EA39E94D4F2F}"/>
              </a:ext>
            </a:extLst>
          </p:cNvPr>
          <p:cNvSpPr/>
          <p:nvPr/>
        </p:nvSpPr>
        <p:spPr>
          <a:xfrm>
            <a:off x="-51390" y="6814174"/>
            <a:ext cx="720208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2. (A) Expression of primary miR-199a-1 and miR-199a-3p in lentiviral transduced SKOV-3 cells. (B) Ki67 staining of tumor tissue samples. (C) Ki67 staining after cisplatin/paclitaxel treatment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DA3D49D2-81BE-804D-B514-3C2FC28ECBAE}"/>
              </a:ext>
            </a:extLst>
          </p:cNvPr>
          <p:cNvGrpSpPr/>
          <p:nvPr/>
        </p:nvGrpSpPr>
        <p:grpSpPr>
          <a:xfrm>
            <a:off x="854201" y="2455051"/>
            <a:ext cx="2156918" cy="2185014"/>
            <a:chOff x="4725898" y="1827154"/>
            <a:chExt cx="2156918" cy="2185014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3DC7644-414B-3940-8D38-BFA889A504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725898" y="2150704"/>
              <a:ext cx="1038860" cy="69088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8A1EC21-A756-4041-B868-F3826F998EF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843956" y="2150704"/>
              <a:ext cx="1038860" cy="690880"/>
            </a:xfrm>
            <a:prstGeom prst="rect">
              <a:avLst/>
            </a:prstGeom>
          </p:spPr>
        </p:pic>
        <p:pic>
          <p:nvPicPr>
            <p:cNvPr id="16" name="Picture 15" descr="Background pattern&#10;&#10;Description automatically generated">
              <a:extLst>
                <a:ext uri="{FF2B5EF4-FFF2-40B4-BE49-F238E27FC236}">
                  <a16:creationId xmlns:a16="http://schemas.microsoft.com/office/drawing/2014/main" id="{3FCDB48D-E89C-7140-877E-33637063FD4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725898" y="2987228"/>
              <a:ext cx="1038860" cy="69088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424B6830-07B2-5D4B-AA68-317DDF30DD1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837544" y="2987228"/>
              <a:ext cx="1038860" cy="69088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D1B7826-01AC-824B-BD93-D921D49F39A6}"/>
                </a:ext>
              </a:extLst>
            </p:cNvPr>
            <p:cNvSpPr txBox="1"/>
            <p:nvPr/>
          </p:nvSpPr>
          <p:spPr>
            <a:xfrm>
              <a:off x="5060741" y="1969306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73E8FFB-8F2E-9443-AAEA-F513C659016C}"/>
                </a:ext>
              </a:extLst>
            </p:cNvPr>
            <p:cNvSpPr txBox="1"/>
            <p:nvPr/>
          </p:nvSpPr>
          <p:spPr>
            <a:xfrm>
              <a:off x="5262948" y="1827154"/>
              <a:ext cx="10246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 miRNA OE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1B3816D-D467-364D-AA09-A1BB7708A22B}"/>
                </a:ext>
              </a:extLst>
            </p:cNvPr>
            <p:cNvSpPr txBox="1"/>
            <p:nvPr/>
          </p:nvSpPr>
          <p:spPr>
            <a:xfrm>
              <a:off x="5320591" y="3765947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 O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3884672-B0E8-DB41-9672-7C6E95FE4F76}"/>
                </a:ext>
              </a:extLst>
            </p:cNvPr>
            <p:cNvSpPr txBox="1"/>
            <p:nvPr/>
          </p:nvSpPr>
          <p:spPr>
            <a:xfrm>
              <a:off x="6132246" y="1976513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6749A19-A36D-C34C-B912-F6B55104B3ED}"/>
                </a:ext>
              </a:extLst>
            </p:cNvPr>
            <p:cNvSpPr txBox="1"/>
            <p:nvPr/>
          </p:nvSpPr>
          <p:spPr>
            <a:xfrm>
              <a:off x="5156498" y="3651470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0046E56-B474-F442-A24E-F6930E8F25CD}"/>
                </a:ext>
              </a:extLst>
            </p:cNvPr>
            <p:cNvSpPr txBox="1"/>
            <p:nvPr/>
          </p:nvSpPr>
          <p:spPr>
            <a:xfrm>
              <a:off x="6248106" y="3651470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02E48729-B00F-7245-9D1E-132000BD8469}"/>
              </a:ext>
            </a:extLst>
          </p:cNvPr>
          <p:cNvGrpSpPr/>
          <p:nvPr/>
        </p:nvGrpSpPr>
        <p:grpSpPr>
          <a:xfrm>
            <a:off x="477084" y="4846211"/>
            <a:ext cx="4766648" cy="1784275"/>
            <a:chOff x="3849" y="7539602"/>
            <a:chExt cx="4766648" cy="1784275"/>
          </a:xfrm>
        </p:grpSpPr>
        <p:pic>
          <p:nvPicPr>
            <p:cNvPr id="34" name="Picture 33" descr="A picture containing food, bread&#10;&#10;Description automatically generated">
              <a:extLst>
                <a:ext uri="{FF2B5EF4-FFF2-40B4-BE49-F238E27FC236}">
                  <a16:creationId xmlns:a16="http://schemas.microsoft.com/office/drawing/2014/main" id="{E33564C7-EFF3-184B-8D09-123D69E5D88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474577" y="7896859"/>
              <a:ext cx="1044971" cy="694944"/>
            </a:xfrm>
            <a:prstGeom prst="rect">
              <a:avLst/>
            </a:prstGeom>
          </p:spPr>
        </p:pic>
        <p:pic>
          <p:nvPicPr>
            <p:cNvPr id="35" name="Picture 34" descr="A close-up of some snow&#10;&#10;Description automatically generated with low confidence">
              <a:extLst>
                <a:ext uri="{FF2B5EF4-FFF2-40B4-BE49-F238E27FC236}">
                  <a16:creationId xmlns:a16="http://schemas.microsoft.com/office/drawing/2014/main" id="{18A9E585-DC96-1743-A587-10C61447097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91419" y="7896859"/>
              <a:ext cx="1044971" cy="694944"/>
            </a:xfrm>
            <a:prstGeom prst="rect">
              <a:avLst/>
            </a:prstGeom>
          </p:spPr>
        </p:pic>
        <p:pic>
          <p:nvPicPr>
            <p:cNvPr id="36" name="Picture 35" descr="Background pattern&#10;&#10;Description automatically generated">
              <a:extLst>
                <a:ext uri="{FF2B5EF4-FFF2-40B4-BE49-F238E27FC236}">
                  <a16:creationId xmlns:a16="http://schemas.microsoft.com/office/drawing/2014/main" id="{AD5859AD-6973-5543-A4F8-47E579A58AB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634820" y="7900923"/>
              <a:ext cx="1038860" cy="690880"/>
            </a:xfrm>
            <a:prstGeom prst="rect">
              <a:avLst/>
            </a:prstGeom>
          </p:spPr>
        </p:pic>
        <p:pic>
          <p:nvPicPr>
            <p:cNvPr id="37" name="Picture 36" descr="A picture containing bread&#10;&#10;Description automatically generated">
              <a:extLst>
                <a:ext uri="{FF2B5EF4-FFF2-40B4-BE49-F238E27FC236}">
                  <a16:creationId xmlns:a16="http://schemas.microsoft.com/office/drawing/2014/main" id="{9B8F665B-7AAF-F04D-B4F8-181A1BBDDF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25526" y="7900923"/>
              <a:ext cx="1038860" cy="690880"/>
            </a:xfrm>
            <a:prstGeom prst="rect">
              <a:avLst/>
            </a:prstGeom>
          </p:spPr>
        </p:pic>
        <p:pic>
          <p:nvPicPr>
            <p:cNvPr id="38" name="Picture 37" descr="Background pattern&#10;&#10;Description automatically generated with medium confidence">
              <a:extLst>
                <a:ext uri="{FF2B5EF4-FFF2-40B4-BE49-F238E27FC236}">
                  <a16:creationId xmlns:a16="http://schemas.microsoft.com/office/drawing/2014/main" id="{7DE6165D-3CD0-3143-916E-6B346DA4259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93568" y="8615850"/>
              <a:ext cx="1038860" cy="690880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C2B6D698-7790-804F-B377-261AF62B06E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474577" y="8615850"/>
              <a:ext cx="1038860" cy="690880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71E18917-799F-404D-A5DC-427F110197C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634820" y="8615850"/>
              <a:ext cx="1038860" cy="690880"/>
            </a:xfrm>
            <a:prstGeom prst="rect">
              <a:avLst/>
            </a:prstGeom>
          </p:spPr>
        </p:pic>
        <p:pic>
          <p:nvPicPr>
            <p:cNvPr id="41" name="Picture 40" descr="A picture containing outdoor, mountain, food, bread&#10;&#10;Description automatically generated">
              <a:extLst>
                <a:ext uri="{FF2B5EF4-FFF2-40B4-BE49-F238E27FC236}">
                  <a16:creationId xmlns:a16="http://schemas.microsoft.com/office/drawing/2014/main" id="{7218253C-DE6C-3342-94D6-E8D3152606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25526" y="8615850"/>
              <a:ext cx="1044971" cy="694944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D7AD864-454B-BA41-84C8-7984257F8A9C}"/>
                </a:ext>
              </a:extLst>
            </p:cNvPr>
            <p:cNvSpPr txBox="1"/>
            <p:nvPr/>
          </p:nvSpPr>
          <p:spPr>
            <a:xfrm>
              <a:off x="738242" y="7689477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B33015F-0CDD-F049-BD54-614A27723631}"/>
                </a:ext>
              </a:extLst>
            </p:cNvPr>
            <p:cNvSpPr txBox="1"/>
            <p:nvPr/>
          </p:nvSpPr>
          <p:spPr>
            <a:xfrm>
              <a:off x="1829850" y="7689477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6DFEBB9-22C0-F44A-AB5D-9FAFD86D880C}"/>
                </a:ext>
              </a:extLst>
            </p:cNvPr>
            <p:cNvSpPr txBox="1"/>
            <p:nvPr/>
          </p:nvSpPr>
          <p:spPr>
            <a:xfrm>
              <a:off x="2983778" y="7685908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095AD3E-62CD-C244-9511-B16565DD85F7}"/>
                </a:ext>
              </a:extLst>
            </p:cNvPr>
            <p:cNvSpPr txBox="1"/>
            <p:nvPr/>
          </p:nvSpPr>
          <p:spPr>
            <a:xfrm>
              <a:off x="4075386" y="7685908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9A0FA96-DE1C-094F-B7B4-CB05A3497804}"/>
                </a:ext>
              </a:extLst>
            </p:cNvPr>
            <p:cNvSpPr txBox="1"/>
            <p:nvPr/>
          </p:nvSpPr>
          <p:spPr>
            <a:xfrm>
              <a:off x="945765" y="7571132"/>
              <a:ext cx="10246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 miRNA OE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51A4D3C-7CBC-4A4A-9D51-23F5CA6ABCE4}"/>
                </a:ext>
              </a:extLst>
            </p:cNvPr>
            <p:cNvSpPr txBox="1"/>
            <p:nvPr/>
          </p:nvSpPr>
          <p:spPr>
            <a:xfrm>
              <a:off x="3131887" y="7539602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 OE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54B52D4-CA4B-114B-AA46-A221A4120B78}"/>
                </a:ext>
              </a:extLst>
            </p:cNvPr>
            <p:cNvSpPr txBox="1"/>
            <p:nvPr/>
          </p:nvSpPr>
          <p:spPr>
            <a:xfrm rot="16200000">
              <a:off x="-179375" y="8740544"/>
              <a:ext cx="7665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clitaxel 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2 mg/kg)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8525E0AF-892E-7D4B-83FB-643B79C3A7D6}"/>
                </a:ext>
              </a:extLst>
            </p:cNvPr>
            <p:cNvSpPr txBox="1"/>
            <p:nvPr/>
          </p:nvSpPr>
          <p:spPr>
            <a:xfrm rot="16200000">
              <a:off x="-154461" y="8036158"/>
              <a:ext cx="7248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isplatin 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5 mg/kg)</a:t>
              </a: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1FBA88AF-1C11-D340-B1C4-398B089EB1FE}"/>
              </a:ext>
            </a:extLst>
          </p:cNvPr>
          <p:cNvSpPr txBox="1"/>
          <p:nvPr/>
        </p:nvSpPr>
        <p:spPr>
          <a:xfrm>
            <a:off x="40764" y="-8141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40D71AC-2B25-7B42-B74C-9284C4CBBEBB}"/>
              </a:ext>
            </a:extLst>
          </p:cNvPr>
          <p:cNvSpPr txBox="1"/>
          <p:nvPr/>
        </p:nvSpPr>
        <p:spPr>
          <a:xfrm>
            <a:off x="36800" y="270127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B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9DF17EB-110F-C342-8B11-0E221E689DA1}"/>
              </a:ext>
            </a:extLst>
          </p:cNvPr>
          <p:cNvSpPr txBox="1"/>
          <p:nvPr/>
        </p:nvSpPr>
        <p:spPr>
          <a:xfrm>
            <a:off x="31146" y="490848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</a:t>
            </a: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B41D9D95-AB9D-7A46-9243-8BA7EAE204A6}"/>
              </a:ext>
            </a:extLst>
          </p:cNvPr>
          <p:cNvGrpSpPr/>
          <p:nvPr/>
        </p:nvGrpSpPr>
        <p:grpSpPr>
          <a:xfrm>
            <a:off x="573820" y="312733"/>
            <a:ext cx="1504455" cy="2362177"/>
            <a:chOff x="3216253" y="2584955"/>
            <a:chExt cx="1504455" cy="236217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365E626-9A11-104F-B924-F4D551B0D9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5110" r="28324"/>
            <a:stretch/>
          </p:blipFill>
          <p:spPr>
            <a:xfrm>
              <a:off x="3409896" y="2584955"/>
              <a:ext cx="1310812" cy="1338439"/>
            </a:xfrm>
            <a:prstGeom prst="rect">
              <a:avLst/>
            </a:prstGeom>
          </p:spPr>
        </p:pic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DBC23AFD-9BF5-784A-8C67-E7C41DF7F2FC}"/>
                </a:ext>
              </a:extLst>
            </p:cNvPr>
            <p:cNvSpPr/>
            <p:nvPr/>
          </p:nvSpPr>
          <p:spPr>
            <a:xfrm rot="16200000">
              <a:off x="2742085" y="3059125"/>
              <a:ext cx="134844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f miR-199a-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F2BD38F-6883-3D40-A578-C660C5609471}"/>
                </a:ext>
              </a:extLst>
            </p:cNvPr>
            <p:cNvSpPr txBox="1"/>
            <p:nvPr/>
          </p:nvSpPr>
          <p:spPr>
            <a:xfrm rot="18767311">
              <a:off x="3152163" y="4126282"/>
              <a:ext cx="1105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enti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891DBD9-1A06-714A-B759-F9EDB49E1FC0}"/>
                </a:ext>
              </a:extLst>
            </p:cNvPr>
            <p:cNvSpPr txBox="1"/>
            <p:nvPr/>
          </p:nvSpPr>
          <p:spPr>
            <a:xfrm rot="18767311">
              <a:off x="3458049" y="4178222"/>
              <a:ext cx="1291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Lenti-199a-1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488395F5-C124-824A-9177-C3F55E8A8E77}"/>
              </a:ext>
            </a:extLst>
          </p:cNvPr>
          <p:cNvGrpSpPr/>
          <p:nvPr/>
        </p:nvGrpSpPr>
        <p:grpSpPr>
          <a:xfrm>
            <a:off x="2537146" y="132109"/>
            <a:ext cx="1662003" cy="2553392"/>
            <a:chOff x="4361212" y="2379008"/>
            <a:chExt cx="1662003" cy="255339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F1A59CF-2CAB-444D-9AC6-FABB50400B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37650" r="31496"/>
            <a:stretch/>
          </p:blipFill>
          <p:spPr>
            <a:xfrm>
              <a:off x="4683412" y="2379008"/>
              <a:ext cx="1339803" cy="1520339"/>
            </a:xfrm>
            <a:prstGeom prst="rect">
              <a:avLst/>
            </a:prstGeom>
          </p:spPr>
        </p:pic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9D158570-30C3-AC4C-82DC-31061626FAA0}"/>
                </a:ext>
              </a:extLst>
            </p:cNvPr>
            <p:cNvSpPr/>
            <p:nvPr/>
          </p:nvSpPr>
          <p:spPr>
            <a:xfrm rot="16200000">
              <a:off x="3887044" y="2921537"/>
              <a:ext cx="134844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f miR-199a-3p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C3EBD59-8B4A-054A-99F8-35A254354855}"/>
                </a:ext>
              </a:extLst>
            </p:cNvPr>
            <p:cNvSpPr txBox="1"/>
            <p:nvPr/>
          </p:nvSpPr>
          <p:spPr>
            <a:xfrm rot="18767311">
              <a:off x="4437028" y="4104317"/>
              <a:ext cx="1105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enti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5831DF6-AF77-B642-9222-C1604CB0AC82}"/>
                </a:ext>
              </a:extLst>
            </p:cNvPr>
            <p:cNvSpPr txBox="1"/>
            <p:nvPr/>
          </p:nvSpPr>
          <p:spPr>
            <a:xfrm rot="18767311">
              <a:off x="4848381" y="4163490"/>
              <a:ext cx="1291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Lenti-199a-1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C8CB3AA8-BB4D-2E2E-DA37-F346286BF9F6}"/>
              </a:ext>
            </a:extLst>
          </p:cNvPr>
          <p:cNvGrpSpPr/>
          <p:nvPr/>
        </p:nvGrpSpPr>
        <p:grpSpPr>
          <a:xfrm>
            <a:off x="1707246" y="3432691"/>
            <a:ext cx="152400" cy="27432"/>
            <a:chOff x="6455045" y="9234487"/>
            <a:chExt cx="152400" cy="27432"/>
          </a:xfrm>
        </p:grpSpPr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48D75D4F-1F4E-CA5E-256B-E87EF0923184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FEB8373E-430B-E3E2-0E2F-B1CB9B3C565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F1B2A4BF-CBD9-EB43-A73B-5E3FC69EE3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9F93F7F2-A8B6-B94A-67EC-E218FA36D8AA}"/>
              </a:ext>
            </a:extLst>
          </p:cNvPr>
          <p:cNvGrpSpPr/>
          <p:nvPr/>
        </p:nvGrpSpPr>
        <p:grpSpPr>
          <a:xfrm>
            <a:off x="2827900" y="3433985"/>
            <a:ext cx="152400" cy="27432"/>
            <a:chOff x="6455045" y="9234487"/>
            <a:chExt cx="152400" cy="27432"/>
          </a:xfrm>
        </p:grpSpPr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5D177BBA-9E61-0159-DC56-C88A9B69B07B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F78E3AC8-844C-E49C-E310-FC3D630E779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B976D4A8-A565-BF9A-0D60-94CE2E084E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FBC50A99-2966-B1EB-E319-B5CA19BFB3B6}"/>
              </a:ext>
            </a:extLst>
          </p:cNvPr>
          <p:cNvGrpSpPr/>
          <p:nvPr/>
        </p:nvGrpSpPr>
        <p:grpSpPr>
          <a:xfrm>
            <a:off x="1707888" y="4271468"/>
            <a:ext cx="152400" cy="27432"/>
            <a:chOff x="6455045" y="9234487"/>
            <a:chExt cx="152400" cy="27432"/>
          </a:xfrm>
        </p:grpSpPr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9CF82EF3-C367-B8D1-1926-DE7387C4BC2E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3184431A-3356-A830-7A88-82FCF90184B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7DFC7940-5584-7383-8210-77EAF424D03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510FC879-A756-0AB1-68DA-351E2F00FF51}"/>
              </a:ext>
            </a:extLst>
          </p:cNvPr>
          <p:cNvGrpSpPr/>
          <p:nvPr/>
        </p:nvGrpSpPr>
        <p:grpSpPr>
          <a:xfrm>
            <a:off x="2826859" y="4273990"/>
            <a:ext cx="152400" cy="27432"/>
            <a:chOff x="6455045" y="9234487"/>
            <a:chExt cx="152400" cy="27432"/>
          </a:xfrm>
        </p:grpSpPr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E3E10CB6-FA0E-DF5C-BD00-20D1C7CBBF73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D9508DEA-1ACC-9A8E-731B-25629AE499D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5C0A0971-E163-DF0C-9B93-ECAE8716AD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43149C99-6626-726A-C0D9-2ABD25715B4E}"/>
              </a:ext>
            </a:extLst>
          </p:cNvPr>
          <p:cNvGrpSpPr/>
          <p:nvPr/>
        </p:nvGrpSpPr>
        <p:grpSpPr>
          <a:xfrm>
            <a:off x="1725607" y="5860743"/>
            <a:ext cx="152400" cy="27432"/>
            <a:chOff x="6455045" y="9234487"/>
            <a:chExt cx="152400" cy="27432"/>
          </a:xfrm>
        </p:grpSpPr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72400F9B-277B-B03E-957A-698EBB0E2B31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09591DA1-2ABC-FF1B-FCFD-F7AEC79BB82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C58C2295-3C5B-1479-EE7D-9C4E87D7D7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69D8E3D5-E3E9-CDCE-0623-E18040A9863E}"/>
              </a:ext>
            </a:extLst>
          </p:cNvPr>
          <p:cNvGrpSpPr/>
          <p:nvPr/>
        </p:nvGrpSpPr>
        <p:grpSpPr>
          <a:xfrm>
            <a:off x="2802909" y="5861376"/>
            <a:ext cx="152400" cy="27432"/>
            <a:chOff x="6455045" y="9234487"/>
            <a:chExt cx="152400" cy="27432"/>
          </a:xfrm>
        </p:grpSpPr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63778169-EB32-D060-6319-959F62514AA5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658622D6-3BCB-C4D7-40BC-5691D4EBB38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2EF4269D-54CF-597C-7895-4C47C46A1F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F80B5604-80C2-2D91-9433-6CA131CDF797}"/>
              </a:ext>
            </a:extLst>
          </p:cNvPr>
          <p:cNvGrpSpPr/>
          <p:nvPr/>
        </p:nvGrpSpPr>
        <p:grpSpPr>
          <a:xfrm>
            <a:off x="1729982" y="6577310"/>
            <a:ext cx="152400" cy="27432"/>
            <a:chOff x="6455045" y="9234487"/>
            <a:chExt cx="152400" cy="27432"/>
          </a:xfrm>
        </p:grpSpPr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1A244ACC-0E79-2C48-A313-E0F9A8233904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38D82664-7825-5F5F-72D8-626D8C64285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CE024D3A-FF83-4A21-FC1B-0F6FA2A60E7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48B2FFAA-0545-FC19-91A7-8A4449219469}"/>
              </a:ext>
            </a:extLst>
          </p:cNvPr>
          <p:cNvGrpSpPr/>
          <p:nvPr/>
        </p:nvGrpSpPr>
        <p:grpSpPr>
          <a:xfrm>
            <a:off x="2803253" y="6578576"/>
            <a:ext cx="152400" cy="27432"/>
            <a:chOff x="6455045" y="9234487"/>
            <a:chExt cx="152400" cy="27432"/>
          </a:xfrm>
        </p:grpSpPr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FE2BF5D1-CF36-5F41-59DF-B584B98C3BF8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FCA18E1B-4FAF-B4A6-AD38-470EA0C4E2A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6BD0D03F-B1C6-50A3-C529-EAD8680A77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453B6F0E-CBB4-121B-7C65-8AC95B91ECBF}"/>
              </a:ext>
            </a:extLst>
          </p:cNvPr>
          <p:cNvGrpSpPr/>
          <p:nvPr/>
        </p:nvGrpSpPr>
        <p:grpSpPr>
          <a:xfrm>
            <a:off x="3969638" y="5861886"/>
            <a:ext cx="152400" cy="27432"/>
            <a:chOff x="6455045" y="9234487"/>
            <a:chExt cx="152400" cy="27432"/>
          </a:xfrm>
        </p:grpSpPr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AC2ED1ED-C265-F478-41DF-6D4B3D92C1B2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0078C6C9-F72C-2D7A-E7B9-5A9EE205DC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6C44A1A0-76DC-679D-C1AB-F87E61B21A7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9D179ADC-3064-AACB-8CD9-87F076000E17}"/>
              </a:ext>
            </a:extLst>
          </p:cNvPr>
          <p:cNvGrpSpPr/>
          <p:nvPr/>
        </p:nvGrpSpPr>
        <p:grpSpPr>
          <a:xfrm>
            <a:off x="5056327" y="5862938"/>
            <a:ext cx="152400" cy="27432"/>
            <a:chOff x="6455045" y="9234487"/>
            <a:chExt cx="152400" cy="27432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17670D08-7F6B-BAF4-C986-F6B01D76221C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C2C00375-696D-A26F-37A7-2C2A272E39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909C73DB-94A8-05E7-DC64-157A5543A07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7F271625-D622-CE78-E1A2-D50E5A95D8D9}"/>
              </a:ext>
            </a:extLst>
          </p:cNvPr>
          <p:cNvGrpSpPr/>
          <p:nvPr/>
        </p:nvGrpSpPr>
        <p:grpSpPr>
          <a:xfrm>
            <a:off x="3966717" y="6577378"/>
            <a:ext cx="152400" cy="27432"/>
            <a:chOff x="6455045" y="9234487"/>
            <a:chExt cx="152400" cy="27432"/>
          </a:xfrm>
        </p:grpSpPr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DE5F4B19-48AC-FB09-F871-768FFF6E66D4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5AA4E5A7-8A09-DA48-BF75-DD70F86DFA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FE74DE5F-F606-9476-C352-864B57DE75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164ECB53-8590-2ED9-1273-4F8A8A584146}"/>
              </a:ext>
            </a:extLst>
          </p:cNvPr>
          <p:cNvGrpSpPr/>
          <p:nvPr/>
        </p:nvGrpSpPr>
        <p:grpSpPr>
          <a:xfrm>
            <a:off x="5064503" y="6580234"/>
            <a:ext cx="152400" cy="27432"/>
            <a:chOff x="6455045" y="9234487"/>
            <a:chExt cx="152400" cy="27432"/>
          </a:xfrm>
        </p:grpSpPr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8652BFD3-6C58-B415-D6AE-C76B0E0F4DE1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B4A069CF-3CC2-D2FB-F7CF-8DFD565100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BE1AFC00-0683-3EA4-6545-34513503984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697515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5D3DE67-EEFF-7B49-B3B2-8A29C94F39C3}"/>
              </a:ext>
            </a:extLst>
          </p:cNvPr>
          <p:cNvSpPr/>
          <p:nvPr/>
        </p:nvSpPr>
        <p:spPr>
          <a:xfrm>
            <a:off x="-56562" y="8557186"/>
            <a:ext cx="720208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3. MiR-199a-3p reduces peritoneal dissemination of A2780/DDP cells and sensitizes them to cisplatin and paclitaxel. (A) Number of tumor nodules and representative images of tumor nodules. (B) Expression of ABCG2, P-</a:t>
            </a:r>
            <a:r>
              <a:rPr lang="en-US" sz="1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nd miR-199a-3p from tumor tissue samples. (C) H&amp;E and (D) Ki67 staining of tumor tissue samples. (E) Number of tumor nodules and representative images for cisplatin and paclitaxel treated group (F) ABCG2, P-</a:t>
            </a:r>
            <a:r>
              <a:rPr lang="en-US" sz="1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iR-199a-3p expression, and (G) H&amp;E staining after cisplatin/paclitaxel treatment. Scale bar, 100 </a:t>
            </a:r>
            <a:r>
              <a:rPr lang="el-GR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. . Bar graph values are mean ± SD, n=3. T-test. *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5, **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05, ***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005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6AE60AD-90B2-0446-B09B-9909642EB059}"/>
              </a:ext>
            </a:extLst>
          </p:cNvPr>
          <p:cNvGrpSpPr/>
          <p:nvPr/>
        </p:nvGrpSpPr>
        <p:grpSpPr>
          <a:xfrm>
            <a:off x="219081" y="100803"/>
            <a:ext cx="1759959" cy="1632398"/>
            <a:chOff x="27888" y="1729719"/>
            <a:chExt cx="1759959" cy="1632398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9317E29F-46D5-4240-8315-41F0E605676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67884982"/>
                </p:ext>
              </p:extLst>
            </p:nvPr>
          </p:nvGraphicFramePr>
          <p:xfrm>
            <a:off x="506697" y="1747189"/>
            <a:ext cx="1281150" cy="12464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6708180-0A3A-E74A-99F9-209B06C88A26}"/>
                </a:ext>
              </a:extLst>
            </p:cNvPr>
            <p:cNvSpPr/>
            <p:nvPr/>
          </p:nvSpPr>
          <p:spPr>
            <a:xfrm rot="16200000">
              <a:off x="-334366" y="2229536"/>
              <a:ext cx="1399743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umber of tumor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dules (Normalized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99E3CB4-C630-8443-B9ED-712290DCDBA8}"/>
                </a:ext>
              </a:extLst>
            </p:cNvPr>
            <p:cNvSpPr txBox="1"/>
            <p:nvPr/>
          </p:nvSpPr>
          <p:spPr>
            <a:xfrm rot="19500000">
              <a:off x="27888" y="3110377"/>
              <a:ext cx="12621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S miRNA O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FE6298E-3BE9-094C-B473-55E9280947A9}"/>
                </a:ext>
              </a:extLst>
            </p:cNvPr>
            <p:cNvSpPr txBox="1"/>
            <p:nvPr/>
          </p:nvSpPr>
          <p:spPr>
            <a:xfrm rot="19500000">
              <a:off x="502089" y="3115896"/>
              <a:ext cx="12621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 O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D0B2360B-6A06-0644-970B-DC9DA4C059B9}"/>
              </a:ext>
            </a:extLst>
          </p:cNvPr>
          <p:cNvGrpSpPr/>
          <p:nvPr/>
        </p:nvGrpSpPr>
        <p:grpSpPr>
          <a:xfrm>
            <a:off x="2312747" y="19227"/>
            <a:ext cx="1328986" cy="2269087"/>
            <a:chOff x="3711278" y="-2673300"/>
            <a:chExt cx="1328986" cy="2269087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C11D94B-A528-9A46-8BB1-8A6C811F3643}"/>
                </a:ext>
              </a:extLst>
            </p:cNvPr>
            <p:cNvGrpSpPr/>
            <p:nvPr/>
          </p:nvGrpSpPr>
          <p:grpSpPr>
            <a:xfrm>
              <a:off x="3711278" y="-2673300"/>
              <a:ext cx="1328986" cy="2060282"/>
              <a:chOff x="3130220" y="27912"/>
              <a:chExt cx="1328986" cy="2060282"/>
            </a:xfrm>
          </p:grpSpPr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C527A390-3B9B-EE4B-8338-F2574881836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30220" y="27912"/>
                <a:ext cx="1322348" cy="914400"/>
                <a:chOff x="1917816" y="1013559"/>
                <a:chExt cx="2856271" cy="1975104"/>
              </a:xfrm>
            </p:grpSpPr>
            <p:pic>
              <p:nvPicPr>
                <p:cNvPr id="14" name="Picture 13" descr="A picture containing plate, indoor, white, eaten&#10;&#10;Description automatically generated">
                  <a:extLst>
                    <a:ext uri="{FF2B5EF4-FFF2-40B4-BE49-F238E27FC236}">
                      <a16:creationId xmlns:a16="http://schemas.microsoft.com/office/drawing/2014/main" id="{39DCFDCF-84FF-9E49-A96D-0A73D925999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917816" y="1013559"/>
                  <a:ext cx="2856271" cy="1975104"/>
                </a:xfrm>
                <a:prstGeom prst="rect">
                  <a:avLst/>
                </a:prstGeom>
              </p:spPr>
            </p:pic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1B0ECE86-9A57-FD4A-A859-6DE5386B2147}"/>
                    </a:ext>
                  </a:extLst>
                </p:cNvPr>
                <p:cNvGrpSpPr/>
                <p:nvPr/>
              </p:nvGrpSpPr>
              <p:grpSpPr>
                <a:xfrm>
                  <a:off x="2773296" y="1920753"/>
                  <a:ext cx="1549784" cy="967981"/>
                  <a:chOff x="2773296" y="1920753"/>
                  <a:chExt cx="1549784" cy="967981"/>
                </a:xfrm>
              </p:grpSpPr>
              <p:cxnSp>
                <p:nvCxnSpPr>
                  <p:cNvPr id="16" name="Straight Arrow Connector 15">
                    <a:extLst>
                      <a:ext uri="{FF2B5EF4-FFF2-40B4-BE49-F238E27FC236}">
                        <a16:creationId xmlns:a16="http://schemas.microsoft.com/office/drawing/2014/main" id="{9C417B1E-98B4-1649-BCD0-FA5C97AA256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168414" y="2194560"/>
                    <a:ext cx="154666" cy="129353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Straight Arrow Connector 16">
                    <a:extLst>
                      <a:ext uri="{FF2B5EF4-FFF2-40B4-BE49-F238E27FC236}">
                        <a16:creationId xmlns:a16="http://schemas.microsoft.com/office/drawing/2014/main" id="{4CDC9ACC-F85D-264D-8AB1-905334621E1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4106321" y="2677727"/>
                    <a:ext cx="139426" cy="211007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Arrow Connector 17">
                    <a:extLst>
                      <a:ext uri="{FF2B5EF4-FFF2-40B4-BE49-F238E27FC236}">
                        <a16:creationId xmlns:a16="http://schemas.microsoft.com/office/drawing/2014/main" id="{E6C722C4-DEF6-C640-B144-4AE79F16342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639690" y="2448560"/>
                    <a:ext cx="69713" cy="229167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Arrow Connector 18">
                    <a:extLst>
                      <a:ext uri="{FF2B5EF4-FFF2-40B4-BE49-F238E27FC236}">
                        <a16:creationId xmlns:a16="http://schemas.microsoft.com/office/drawing/2014/main" id="{12305288-9697-0E45-8B69-758B7291F1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111351" y="2485574"/>
                    <a:ext cx="131421" cy="204334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Arrow Connector 19">
                    <a:extLst>
                      <a:ext uri="{FF2B5EF4-FFF2-40B4-BE49-F238E27FC236}">
                        <a16:creationId xmlns:a16="http://schemas.microsoft.com/office/drawing/2014/main" id="{166650ED-D0B2-1A42-93C7-0C2BD9DF82F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3840480" y="2160669"/>
                    <a:ext cx="196129" cy="33891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Arrow Connector 20">
                    <a:extLst>
                      <a:ext uri="{FF2B5EF4-FFF2-40B4-BE49-F238E27FC236}">
                        <a16:creationId xmlns:a16="http://schemas.microsoft.com/office/drawing/2014/main" id="{CD7758AF-6866-7642-8F89-46B58559A0F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11351" y="1920753"/>
                    <a:ext cx="21699" cy="19432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Arrow Connector 21">
                    <a:extLst>
                      <a:ext uri="{FF2B5EF4-FFF2-40B4-BE49-F238E27FC236}">
                        <a16:creationId xmlns:a16="http://schemas.microsoft.com/office/drawing/2014/main" id="{38F266E2-1C6A-FA49-B3B0-039F2AFFA14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773296" y="1920753"/>
                    <a:ext cx="105754" cy="19432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8F3927D9-C52B-594D-B70D-2BBBC7CA055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36859" y="1173794"/>
                <a:ext cx="1322347" cy="914400"/>
                <a:chOff x="5341326" y="2839985"/>
                <a:chExt cx="2856270" cy="1975104"/>
              </a:xfrm>
            </p:grpSpPr>
            <p:pic>
              <p:nvPicPr>
                <p:cNvPr id="24" name="Picture 23" descr="A dead fish on a plat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2AFADDCD-5157-B343-A32A-D376699029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341326" y="2839985"/>
                  <a:ext cx="2856270" cy="1975104"/>
                </a:xfrm>
                <a:prstGeom prst="rect">
                  <a:avLst/>
                </a:prstGeom>
              </p:spPr>
            </p:pic>
            <p:cxnSp>
              <p:nvCxnSpPr>
                <p:cNvPr id="25" name="Straight Arrow Connector 24">
                  <a:extLst>
                    <a:ext uri="{FF2B5EF4-FFF2-40B4-BE49-F238E27FC236}">
                      <a16:creationId xmlns:a16="http://schemas.microsoft.com/office/drawing/2014/main" id="{9FECF247-904A-394A-A645-1FA050C734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6315632" y="3680998"/>
                  <a:ext cx="190271" cy="217827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Arrow Connector 25">
                  <a:extLst>
                    <a:ext uri="{FF2B5EF4-FFF2-40B4-BE49-F238E27FC236}">
                      <a16:creationId xmlns:a16="http://schemas.microsoft.com/office/drawing/2014/main" id="{3FF81572-3B68-1042-B48F-564C0E02D2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7001520" y="3473126"/>
                  <a:ext cx="190271" cy="217827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Arrow Connector 26">
                  <a:extLst>
                    <a:ext uri="{FF2B5EF4-FFF2-40B4-BE49-F238E27FC236}">
                      <a16:creationId xmlns:a16="http://schemas.microsoft.com/office/drawing/2014/main" id="{46C75F97-3986-A44D-95CA-8AD4455975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243098" y="3894584"/>
                  <a:ext cx="202184" cy="193882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1D9A0D95-D08E-234B-9AF6-240AD93FB254}"/>
                  </a:ext>
                </a:extLst>
              </p:cNvPr>
              <p:cNvSpPr txBox="1"/>
              <p:nvPr/>
            </p:nvSpPr>
            <p:spPr>
              <a:xfrm>
                <a:off x="3217327" y="903502"/>
                <a:ext cx="10246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S miRNA OE</a:t>
                </a: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2B34DE3-9108-B242-BE7A-239CB3574700}"/>
                </a:ext>
              </a:extLst>
            </p:cNvPr>
            <p:cNvSpPr txBox="1"/>
            <p:nvPr/>
          </p:nvSpPr>
          <p:spPr>
            <a:xfrm>
              <a:off x="3796161" y="-650434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 OE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7CFCA42B-5D6E-3644-93A6-031647B9E5F8}"/>
              </a:ext>
            </a:extLst>
          </p:cNvPr>
          <p:cNvSpPr txBox="1"/>
          <p:nvPr/>
        </p:nvSpPr>
        <p:spPr>
          <a:xfrm>
            <a:off x="34287" y="-7222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0735288-01E9-8F46-A8C6-1EE539B23A1E}"/>
              </a:ext>
            </a:extLst>
          </p:cNvPr>
          <p:cNvSpPr txBox="1"/>
          <p:nvPr/>
        </p:nvSpPr>
        <p:spPr>
          <a:xfrm>
            <a:off x="4401574" y="-7222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B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E49EC76-D673-064A-8E17-1A9CF8CFBBDE}"/>
              </a:ext>
            </a:extLst>
          </p:cNvPr>
          <p:cNvSpPr txBox="1"/>
          <p:nvPr/>
        </p:nvSpPr>
        <p:spPr>
          <a:xfrm>
            <a:off x="39898" y="670127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F</a:t>
            </a:r>
          </a:p>
        </p:txBody>
      </p:sp>
      <p:grpSp>
        <p:nvGrpSpPr>
          <p:cNvPr id="94" name="Group 93">
            <a:extLst>
              <a:ext uri="{FF2B5EF4-FFF2-40B4-BE49-F238E27FC236}">
                <a16:creationId xmlns:a16="http://schemas.microsoft.com/office/drawing/2014/main" id="{FFE727FE-7E9F-6346-B177-84DAD43FFC85}"/>
              </a:ext>
            </a:extLst>
          </p:cNvPr>
          <p:cNvGrpSpPr/>
          <p:nvPr/>
        </p:nvGrpSpPr>
        <p:grpSpPr>
          <a:xfrm>
            <a:off x="3858777" y="4468328"/>
            <a:ext cx="3248661" cy="2070341"/>
            <a:chOff x="3858777" y="3519621"/>
            <a:chExt cx="3248661" cy="2070341"/>
          </a:xfrm>
        </p:grpSpPr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AF476467-70E7-C645-84AE-5C5DEF0D4CF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328424" y="3720418"/>
              <a:ext cx="1317865" cy="914400"/>
              <a:chOff x="1932789" y="3823656"/>
              <a:chExt cx="2841298" cy="1971433"/>
            </a:xfrm>
          </p:grpSpPr>
          <p:pic>
            <p:nvPicPr>
              <p:cNvPr id="64" name="Picture 63" descr="A picture containing indoor, eaten&#10;&#10;Description automatically generated">
                <a:extLst>
                  <a:ext uri="{FF2B5EF4-FFF2-40B4-BE49-F238E27FC236}">
                    <a16:creationId xmlns:a16="http://schemas.microsoft.com/office/drawing/2014/main" id="{53352799-EC9C-2340-85DA-AA53D2130D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932789" y="3823656"/>
                <a:ext cx="2841298" cy="1971433"/>
              </a:xfrm>
              <a:prstGeom prst="rect">
                <a:avLst/>
              </a:prstGeom>
            </p:spPr>
          </p:pic>
          <p:cxnSp>
            <p:nvCxnSpPr>
              <p:cNvPr id="65" name="Straight Arrow Connector 64">
                <a:extLst>
                  <a:ext uri="{FF2B5EF4-FFF2-40B4-BE49-F238E27FC236}">
                    <a16:creationId xmlns:a16="http://schemas.microsoft.com/office/drawing/2014/main" id="{93F37C6F-E216-564E-8FE6-66568D8C56F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022312" y="4404307"/>
                <a:ext cx="323639" cy="7843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>
                <a:extLst>
                  <a:ext uri="{FF2B5EF4-FFF2-40B4-BE49-F238E27FC236}">
                    <a16:creationId xmlns:a16="http://schemas.microsoft.com/office/drawing/2014/main" id="{143B9AED-FA98-A54D-A6F3-D00BC633547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011185" y="4482740"/>
                <a:ext cx="190271" cy="21782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559C6553-1F1F-A14F-A459-7EEB6C47480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73647" y="3720418"/>
              <a:ext cx="1322347" cy="914400"/>
              <a:chOff x="4952288" y="2822028"/>
              <a:chExt cx="2856271" cy="1975105"/>
            </a:xfrm>
          </p:grpSpPr>
          <p:pic>
            <p:nvPicPr>
              <p:cNvPr id="68" name="Picture 67" descr="A crab on a plate&#10;&#10;Description automatically generated with low confidence">
                <a:extLst>
                  <a:ext uri="{FF2B5EF4-FFF2-40B4-BE49-F238E27FC236}">
                    <a16:creationId xmlns:a16="http://schemas.microsoft.com/office/drawing/2014/main" id="{A6B92963-B24F-8A46-A635-1FD28EBB7F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696"/>
              <a:stretch/>
            </p:blipFill>
            <p:spPr>
              <a:xfrm>
                <a:off x="4952288" y="2822028"/>
                <a:ext cx="2856271" cy="1975105"/>
              </a:xfrm>
              <a:prstGeom prst="rect">
                <a:avLst/>
              </a:prstGeom>
            </p:spPr>
          </p:pic>
          <p:cxnSp>
            <p:nvCxnSpPr>
              <p:cNvPr id="69" name="Straight Arrow Connector 68">
                <a:extLst>
                  <a:ext uri="{FF2B5EF4-FFF2-40B4-BE49-F238E27FC236}">
                    <a16:creationId xmlns:a16="http://schemas.microsoft.com/office/drawing/2014/main" id="{F8EA4041-4071-E443-B5A4-753A7A8FF5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917656" y="3668433"/>
                <a:ext cx="115075" cy="18601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BC8CD27F-4212-A640-AFA3-63976744E64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347194" y="4675562"/>
              <a:ext cx="1324287" cy="914400"/>
              <a:chOff x="1920432" y="4762938"/>
              <a:chExt cx="2841298" cy="1961873"/>
            </a:xfrm>
          </p:grpSpPr>
          <p:pic>
            <p:nvPicPr>
              <p:cNvPr id="71" name="Picture 70" descr="A picture containing white, rodent&#10;&#10;Description automatically generated">
                <a:extLst>
                  <a:ext uri="{FF2B5EF4-FFF2-40B4-BE49-F238E27FC236}">
                    <a16:creationId xmlns:a16="http://schemas.microsoft.com/office/drawing/2014/main" id="{887755D6-9DD5-DC4D-949D-3FEA69C1B8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920432" y="4762938"/>
                <a:ext cx="2841298" cy="1961873"/>
              </a:xfrm>
              <a:prstGeom prst="rect">
                <a:avLst/>
              </a:prstGeom>
            </p:spPr>
          </p:pic>
          <p:cxnSp>
            <p:nvCxnSpPr>
              <p:cNvPr id="72" name="Straight Arrow Connector 71">
                <a:extLst>
                  <a:ext uri="{FF2B5EF4-FFF2-40B4-BE49-F238E27FC236}">
                    <a16:creationId xmlns:a16="http://schemas.microsoft.com/office/drawing/2014/main" id="{ACA2708D-77D8-B640-AE08-16B0EA333F3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219443" y="5072203"/>
                <a:ext cx="266249" cy="984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Arrow Connector 72">
                <a:extLst>
                  <a:ext uri="{FF2B5EF4-FFF2-40B4-BE49-F238E27FC236}">
                    <a16:creationId xmlns:a16="http://schemas.microsoft.com/office/drawing/2014/main" id="{6060102D-D17E-A746-9F7B-C0832BB438C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564642" y="5553661"/>
                <a:ext cx="195094" cy="21745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74" name="Picture 73" descr="A crab on a white surface&#10;&#10;Description automatically generated with medium confidence">
              <a:extLst>
                <a:ext uri="{FF2B5EF4-FFF2-40B4-BE49-F238E27FC236}">
                  <a16:creationId xmlns:a16="http://schemas.microsoft.com/office/drawing/2014/main" id="{5750B441-7403-7445-B273-35A78FBA29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83973" y="4675562"/>
              <a:ext cx="1323465" cy="914400"/>
            </a:xfrm>
            <a:prstGeom prst="rect">
              <a:avLst/>
            </a:prstGeom>
          </p:spPr>
        </p:pic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B8F4B20A-144E-FC4D-8EDD-8142E31184AE}"/>
                </a:ext>
              </a:extLst>
            </p:cNvPr>
            <p:cNvSpPr txBox="1"/>
            <p:nvPr/>
          </p:nvSpPr>
          <p:spPr>
            <a:xfrm>
              <a:off x="4401060" y="3526878"/>
              <a:ext cx="10246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 miRNA OE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939CDAC7-B31A-0C46-9B0F-4F42FC594AF7}"/>
                </a:ext>
              </a:extLst>
            </p:cNvPr>
            <p:cNvSpPr txBox="1"/>
            <p:nvPr/>
          </p:nvSpPr>
          <p:spPr>
            <a:xfrm>
              <a:off x="5887933" y="3519621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 OE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32C95CBF-90D4-194C-831A-1D1B2968135C}"/>
                </a:ext>
              </a:extLst>
            </p:cNvPr>
            <p:cNvSpPr txBox="1"/>
            <p:nvPr/>
          </p:nvSpPr>
          <p:spPr>
            <a:xfrm rot="16200000">
              <a:off x="3675553" y="4902379"/>
              <a:ext cx="7665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clitaxel 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2 mg/kg)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7AE711F4-ECE6-BB49-A9BC-41464507C466}"/>
                </a:ext>
              </a:extLst>
            </p:cNvPr>
            <p:cNvSpPr txBox="1"/>
            <p:nvPr/>
          </p:nvSpPr>
          <p:spPr>
            <a:xfrm rot="16200000">
              <a:off x="3722907" y="3992789"/>
              <a:ext cx="7248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isplatin 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5 mg/kg)</a:t>
              </a:r>
            </a:p>
          </p:txBody>
        </p: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id="{B34C11C5-ECB6-2448-AF16-DE54AC75F290}"/>
              </a:ext>
            </a:extLst>
          </p:cNvPr>
          <p:cNvSpPr txBox="1"/>
          <p:nvPr/>
        </p:nvSpPr>
        <p:spPr>
          <a:xfrm>
            <a:off x="5153" y="46549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E</a:t>
            </a:r>
          </a:p>
        </p:txBody>
      </p:sp>
      <p:grpSp>
        <p:nvGrpSpPr>
          <p:cNvPr id="77" name="Group 76">
            <a:extLst>
              <a:ext uri="{FF2B5EF4-FFF2-40B4-BE49-F238E27FC236}">
                <a16:creationId xmlns:a16="http://schemas.microsoft.com/office/drawing/2014/main" id="{FAE91A0B-43D8-8540-B377-E17A6AE6FCC2}"/>
              </a:ext>
            </a:extLst>
          </p:cNvPr>
          <p:cNvGrpSpPr/>
          <p:nvPr/>
        </p:nvGrpSpPr>
        <p:grpSpPr>
          <a:xfrm>
            <a:off x="466201" y="2636084"/>
            <a:ext cx="1143262" cy="1803031"/>
            <a:chOff x="3093498" y="1436468"/>
            <a:chExt cx="1143262" cy="1803031"/>
          </a:xfrm>
        </p:grpSpPr>
        <p:pic>
          <p:nvPicPr>
            <p:cNvPr id="37" name="Picture 36" descr="Background pattern&#10;&#10;Description automatically generated with medium confidence">
              <a:extLst>
                <a:ext uri="{FF2B5EF4-FFF2-40B4-BE49-F238E27FC236}">
                  <a16:creationId xmlns:a16="http://schemas.microsoft.com/office/drawing/2014/main" id="{B3C35B51-1F20-B146-9A8B-884CE180C31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18881" y="1436468"/>
              <a:ext cx="1044971" cy="694944"/>
            </a:xfrm>
            <a:prstGeom prst="rect">
              <a:avLst/>
            </a:prstGeom>
          </p:spPr>
        </p:pic>
        <p:pic>
          <p:nvPicPr>
            <p:cNvPr id="38" name="Picture 37" descr="A picture containing bedclothes, fabric&#10;&#10;Description automatically generated">
              <a:extLst>
                <a:ext uri="{FF2B5EF4-FFF2-40B4-BE49-F238E27FC236}">
                  <a16:creationId xmlns:a16="http://schemas.microsoft.com/office/drawing/2014/main" id="{2B18EA99-F91F-C043-AD4B-10111FCF219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18882" y="2355863"/>
              <a:ext cx="1044971" cy="694944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9AEE2CE-6D9F-5C45-810E-0443BA1D34A7}"/>
                </a:ext>
              </a:extLst>
            </p:cNvPr>
            <p:cNvSpPr txBox="1"/>
            <p:nvPr/>
          </p:nvSpPr>
          <p:spPr>
            <a:xfrm>
              <a:off x="3139214" y="2067008"/>
              <a:ext cx="10246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 miRNA OE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5B27218-B84A-2845-8108-9EFEF9D3200C}"/>
                </a:ext>
              </a:extLst>
            </p:cNvPr>
            <p:cNvSpPr txBox="1"/>
            <p:nvPr/>
          </p:nvSpPr>
          <p:spPr>
            <a:xfrm>
              <a:off x="3093498" y="2993278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 OE</a:t>
              </a:r>
            </a:p>
          </p:txBody>
        </p:sp>
      </p:grpSp>
      <p:grpSp>
        <p:nvGrpSpPr>
          <p:cNvPr id="99" name="Group 98">
            <a:extLst>
              <a:ext uri="{FF2B5EF4-FFF2-40B4-BE49-F238E27FC236}">
                <a16:creationId xmlns:a16="http://schemas.microsoft.com/office/drawing/2014/main" id="{2F7B1881-4BEA-2044-9FFE-56B6C88998F0}"/>
              </a:ext>
            </a:extLst>
          </p:cNvPr>
          <p:cNvGrpSpPr/>
          <p:nvPr/>
        </p:nvGrpSpPr>
        <p:grpSpPr>
          <a:xfrm>
            <a:off x="4495406" y="6636054"/>
            <a:ext cx="2592759" cy="1643931"/>
            <a:chOff x="4495406" y="5497095"/>
            <a:chExt cx="2592759" cy="1643931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B33CF0AD-1FDE-2141-AF33-632F01B6F979}"/>
                </a:ext>
              </a:extLst>
            </p:cNvPr>
            <p:cNvGrpSpPr/>
            <p:nvPr/>
          </p:nvGrpSpPr>
          <p:grpSpPr>
            <a:xfrm>
              <a:off x="4495406" y="5497095"/>
              <a:ext cx="2592759" cy="1643931"/>
              <a:chOff x="4495406" y="6192284"/>
              <a:chExt cx="2592759" cy="1643931"/>
            </a:xfrm>
          </p:grpSpPr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3550BB41-FA41-6648-9451-80E43BD12ED9}"/>
                  </a:ext>
                </a:extLst>
              </p:cNvPr>
              <p:cNvSpPr txBox="1"/>
              <p:nvPr/>
            </p:nvSpPr>
            <p:spPr>
              <a:xfrm rot="16200000">
                <a:off x="4312182" y="7252882"/>
                <a:ext cx="7665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clitaxel </a:t>
                </a:r>
              </a:p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2 mg/kg)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9E705D1A-80B9-6F43-83B1-0FCD591CCBA8}"/>
                  </a:ext>
                </a:extLst>
              </p:cNvPr>
              <p:cNvSpPr txBox="1"/>
              <p:nvPr/>
            </p:nvSpPr>
            <p:spPr>
              <a:xfrm rot="16200000">
                <a:off x="4337504" y="6481176"/>
                <a:ext cx="72487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isplatin </a:t>
                </a:r>
              </a:p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5 mg/kg)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8BD1BCB5-833F-B34F-9CCA-A7E28068F197}"/>
                  </a:ext>
                </a:extLst>
              </p:cNvPr>
              <p:cNvSpPr txBox="1"/>
              <p:nvPr/>
            </p:nvSpPr>
            <p:spPr>
              <a:xfrm>
                <a:off x="4908041" y="6199626"/>
                <a:ext cx="10246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S miRNA OE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818987B-23E5-1142-96A4-D04DE9BE1F26}"/>
                  </a:ext>
                </a:extLst>
              </p:cNvPr>
              <p:cNvSpPr txBox="1"/>
              <p:nvPr/>
            </p:nvSpPr>
            <p:spPr>
              <a:xfrm>
                <a:off x="5944903" y="6192284"/>
                <a:ext cx="1143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199a-3p OE</a:t>
                </a:r>
              </a:p>
            </p:txBody>
          </p:sp>
        </p:grpSp>
        <p:pic>
          <p:nvPicPr>
            <p:cNvPr id="95" name="Picture 94" descr="Background pattern&#10;&#10;Description automatically generated">
              <a:extLst>
                <a:ext uri="{FF2B5EF4-FFF2-40B4-BE49-F238E27FC236}">
                  <a16:creationId xmlns:a16="http://schemas.microsoft.com/office/drawing/2014/main" id="{D828B25F-28EB-E84C-89BA-66FC7BD175FD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903216" y="5706639"/>
              <a:ext cx="1044971" cy="694944"/>
            </a:xfrm>
            <a:prstGeom prst="rect">
              <a:avLst/>
            </a:prstGeom>
          </p:spPr>
        </p:pic>
        <p:pic>
          <p:nvPicPr>
            <p:cNvPr id="96" name="Picture 95" descr="Background pattern&#10;&#10;Description automatically generated">
              <a:extLst>
                <a:ext uri="{FF2B5EF4-FFF2-40B4-BE49-F238E27FC236}">
                  <a16:creationId xmlns:a16="http://schemas.microsoft.com/office/drawing/2014/main" id="{88CF00E7-B2FD-4C41-9C47-49F4BEA3583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987013" y="5705763"/>
              <a:ext cx="1044971" cy="694944"/>
            </a:xfrm>
            <a:prstGeom prst="rect">
              <a:avLst/>
            </a:prstGeom>
          </p:spPr>
        </p:pic>
        <p:pic>
          <p:nvPicPr>
            <p:cNvPr id="97" name="Picture 96" descr="Background pattern&#10;&#10;Description automatically generated">
              <a:extLst>
                <a:ext uri="{FF2B5EF4-FFF2-40B4-BE49-F238E27FC236}">
                  <a16:creationId xmlns:a16="http://schemas.microsoft.com/office/drawing/2014/main" id="{0A5E21B8-64CE-F247-96FF-4AE88AEA430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908828" y="6438176"/>
              <a:ext cx="1044971" cy="694944"/>
            </a:xfrm>
            <a:prstGeom prst="rect">
              <a:avLst/>
            </a:prstGeom>
          </p:spPr>
        </p:pic>
        <p:pic>
          <p:nvPicPr>
            <p:cNvPr id="98" name="Picture 97" descr="Background pattern&#10;&#10;Description automatically generated">
              <a:extLst>
                <a:ext uri="{FF2B5EF4-FFF2-40B4-BE49-F238E27FC236}">
                  <a16:creationId xmlns:a16="http://schemas.microsoft.com/office/drawing/2014/main" id="{2013A7D4-5B6D-6A41-8706-6094E553E0F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986526" y="6434070"/>
              <a:ext cx="1044971" cy="694944"/>
            </a:xfrm>
            <a:prstGeom prst="rect">
              <a:avLst/>
            </a:prstGeom>
          </p:spPr>
        </p:pic>
      </p:grpSp>
      <p:cxnSp>
        <p:nvCxnSpPr>
          <p:cNvPr id="179" name="Straight Arrow Connector 178">
            <a:extLst>
              <a:ext uri="{FF2B5EF4-FFF2-40B4-BE49-F238E27FC236}">
                <a16:creationId xmlns:a16="http://schemas.microsoft.com/office/drawing/2014/main" id="{28EDF717-3690-EA41-9402-D70A6C241F02}"/>
              </a:ext>
            </a:extLst>
          </p:cNvPr>
          <p:cNvCxnSpPr>
            <a:cxnSpLocks/>
          </p:cNvCxnSpPr>
          <p:nvPr/>
        </p:nvCxnSpPr>
        <p:spPr>
          <a:xfrm flipH="1">
            <a:off x="6619246" y="5627403"/>
            <a:ext cx="90930" cy="1013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6">
            <a:extLst>
              <a:ext uri="{FF2B5EF4-FFF2-40B4-BE49-F238E27FC236}">
                <a16:creationId xmlns:a16="http://schemas.microsoft.com/office/drawing/2014/main" id="{9FC73B24-ABEA-254E-B304-3FF1992BBAB8}"/>
              </a:ext>
            </a:extLst>
          </p:cNvPr>
          <p:cNvSpPr txBox="1"/>
          <p:nvPr/>
        </p:nvSpPr>
        <p:spPr>
          <a:xfrm>
            <a:off x="1515579" y="775802"/>
            <a:ext cx="463461" cy="261348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/>
              <a:t>*</a:t>
            </a:r>
          </a:p>
        </p:txBody>
      </p:sp>
      <p:grpSp>
        <p:nvGrpSpPr>
          <p:cNvPr id="86" name="Group 85">
            <a:extLst>
              <a:ext uri="{FF2B5EF4-FFF2-40B4-BE49-F238E27FC236}">
                <a16:creationId xmlns:a16="http://schemas.microsoft.com/office/drawing/2014/main" id="{26A55DA9-E6FC-2F42-A9B8-4F7D1EA0012E}"/>
              </a:ext>
            </a:extLst>
          </p:cNvPr>
          <p:cNvGrpSpPr/>
          <p:nvPr/>
        </p:nvGrpSpPr>
        <p:grpSpPr>
          <a:xfrm>
            <a:off x="204454" y="4622591"/>
            <a:ext cx="1840709" cy="1766293"/>
            <a:chOff x="204454" y="3644856"/>
            <a:chExt cx="1840709" cy="1766293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9DE40590-95C2-C344-8379-21A78483FD2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23557747"/>
                </p:ext>
              </p:extLst>
            </p:nvPr>
          </p:nvGraphicFramePr>
          <p:xfrm>
            <a:off x="708770" y="3753933"/>
            <a:ext cx="1281150" cy="12464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95F469B2-2B18-B94F-87B5-D6C4536B0F18}"/>
                </a:ext>
              </a:extLst>
            </p:cNvPr>
            <p:cNvSpPr/>
            <p:nvPr/>
          </p:nvSpPr>
          <p:spPr>
            <a:xfrm rot="16200000">
              <a:off x="-128264" y="4144673"/>
              <a:ext cx="1399743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umber of tumor </a:t>
              </a:r>
            </a:p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dules (Normalized)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AC5BEA0-8E57-D541-AE14-96661BE4CA81}"/>
                </a:ext>
              </a:extLst>
            </p:cNvPr>
            <p:cNvSpPr txBox="1"/>
            <p:nvPr/>
          </p:nvSpPr>
          <p:spPr>
            <a:xfrm rot="19500000">
              <a:off x="204454" y="5164927"/>
              <a:ext cx="12621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S miRNA O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A363330-010B-AC4B-B3D5-270A90E9DD9E}"/>
                </a:ext>
              </a:extLst>
            </p:cNvPr>
            <p:cNvSpPr txBox="1"/>
            <p:nvPr/>
          </p:nvSpPr>
          <p:spPr>
            <a:xfrm rot="19500000">
              <a:off x="713482" y="5164928"/>
              <a:ext cx="12621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 O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FB14E2E2-94AF-1843-BCD1-77707D47C854}"/>
                </a:ext>
              </a:extLst>
            </p:cNvPr>
            <p:cNvSpPr txBox="1"/>
            <p:nvPr/>
          </p:nvSpPr>
          <p:spPr>
            <a:xfrm>
              <a:off x="892759" y="3717105"/>
              <a:ext cx="115240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5 mg/kg Cisplatin</a:t>
              </a:r>
              <a:endParaRPr 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0" name="TextBox 6">
            <a:extLst>
              <a:ext uri="{FF2B5EF4-FFF2-40B4-BE49-F238E27FC236}">
                <a16:creationId xmlns:a16="http://schemas.microsoft.com/office/drawing/2014/main" id="{B59B5D92-1E8A-D743-8697-C83FACF83DD1}"/>
              </a:ext>
            </a:extLst>
          </p:cNvPr>
          <p:cNvSpPr txBox="1"/>
          <p:nvPr/>
        </p:nvSpPr>
        <p:spPr>
          <a:xfrm>
            <a:off x="1527993" y="5296703"/>
            <a:ext cx="463461" cy="261348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/>
              <a:t>*</a:t>
            </a:r>
          </a:p>
        </p:txBody>
      </p: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CFF4C0D1-D8DF-A64D-99AE-704A00E7CECD}"/>
              </a:ext>
            </a:extLst>
          </p:cNvPr>
          <p:cNvGrpSpPr/>
          <p:nvPr/>
        </p:nvGrpSpPr>
        <p:grpSpPr>
          <a:xfrm>
            <a:off x="1956009" y="4616423"/>
            <a:ext cx="1881747" cy="1760683"/>
            <a:chOff x="1956009" y="4654691"/>
            <a:chExt cx="1881747" cy="1760683"/>
          </a:xfrm>
        </p:grpSpPr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FF62E6A1-250C-3845-883E-BBACDD9724EE}"/>
                </a:ext>
              </a:extLst>
            </p:cNvPr>
            <p:cNvGrpSpPr/>
            <p:nvPr/>
          </p:nvGrpSpPr>
          <p:grpSpPr>
            <a:xfrm>
              <a:off x="1956009" y="4654691"/>
              <a:ext cx="1881747" cy="1760683"/>
              <a:chOff x="1956009" y="3638688"/>
              <a:chExt cx="1881747" cy="1760683"/>
            </a:xfrm>
          </p:grpSpPr>
          <p:sp>
            <p:nvSpPr>
              <p:cNvPr id="59" name="Rectangle 58">
                <a:extLst>
                  <a:ext uri="{FF2B5EF4-FFF2-40B4-BE49-F238E27FC236}">
                    <a16:creationId xmlns:a16="http://schemas.microsoft.com/office/drawing/2014/main" id="{5DDFB554-41E1-A447-9DD7-4EEEBBF14D36}"/>
                  </a:ext>
                </a:extLst>
              </p:cNvPr>
              <p:cNvSpPr/>
              <p:nvPr/>
            </p:nvSpPr>
            <p:spPr>
              <a:xfrm rot="16200000">
                <a:off x="1612072" y="4138505"/>
                <a:ext cx="1399743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defRPr sz="700" b="0" i="0" u="none" strike="noStrike" kern="1200" baseline="0">
                    <a:solidFill>
                      <a:prstClr val="black"/>
                    </a:solidFill>
                    <a:latin typeface="Arial Unicode MS" panose="020B0604020202020204" pitchFamily="34" charset="-120"/>
                    <a:ea typeface="Arial Unicode MS" panose="020B0604020202020204" pitchFamily="34" charset="-120"/>
                    <a:cs typeface="Arial Unicode MS" panose="020B0604020202020204" pitchFamily="34" charset="-120"/>
                  </a:defRPr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tumor </a:t>
                </a:r>
              </a:p>
              <a:p>
                <a:pPr algn="ctr">
                  <a:defRPr sz="700" b="0" i="0" u="none" strike="noStrike" kern="1200" baseline="0">
                    <a:solidFill>
                      <a:prstClr val="black"/>
                    </a:solidFill>
                    <a:latin typeface="Arial Unicode MS" panose="020B0604020202020204" pitchFamily="34" charset="-120"/>
                    <a:ea typeface="Arial Unicode MS" panose="020B0604020202020204" pitchFamily="34" charset="-120"/>
                    <a:cs typeface="Arial Unicode MS" panose="020B0604020202020204" pitchFamily="34" charset="-120"/>
                  </a:defRPr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dules (Normalized)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9525E06-C1DC-E242-ABAC-BACD5508D468}"/>
                  </a:ext>
                </a:extLst>
              </p:cNvPr>
              <p:cNvSpPr txBox="1"/>
              <p:nvPr/>
            </p:nvSpPr>
            <p:spPr>
              <a:xfrm rot="19500000">
                <a:off x="1956009" y="5153149"/>
                <a:ext cx="12621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S miRNA OE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93F164B7-422F-634C-9D3D-B04A45F4C1EB}"/>
                  </a:ext>
                </a:extLst>
              </p:cNvPr>
              <p:cNvSpPr txBox="1"/>
              <p:nvPr/>
            </p:nvSpPr>
            <p:spPr>
              <a:xfrm rot="19500000">
                <a:off x="2461286" y="5153150"/>
                <a:ext cx="12621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199a-3p OE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A2F01608-9C6C-5345-883F-6B16E5FE21D8}"/>
                  </a:ext>
                </a:extLst>
              </p:cNvPr>
              <p:cNvSpPr txBox="1"/>
              <p:nvPr/>
            </p:nvSpPr>
            <p:spPr>
              <a:xfrm>
                <a:off x="2685352" y="3731467"/>
                <a:ext cx="115240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 mg/kg Paclitaxel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149" name="Chart 148">
              <a:extLst>
                <a:ext uri="{FF2B5EF4-FFF2-40B4-BE49-F238E27FC236}">
                  <a16:creationId xmlns:a16="http://schemas.microsoft.com/office/drawing/2014/main" id="{C036E58C-7004-3647-8ABA-D4B59B2DB7A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18884110"/>
                </p:ext>
              </p:extLst>
            </p:nvPr>
          </p:nvGraphicFramePr>
          <p:xfrm>
            <a:off x="2452532" y="4791151"/>
            <a:ext cx="1281150" cy="12464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sp>
          <p:nvSpPr>
            <p:cNvPr id="151" name="TextBox 6">
              <a:extLst>
                <a:ext uri="{FF2B5EF4-FFF2-40B4-BE49-F238E27FC236}">
                  <a16:creationId xmlns:a16="http://schemas.microsoft.com/office/drawing/2014/main" id="{F5655DA8-7353-854C-B836-C26EB50B14C4}"/>
                </a:ext>
              </a:extLst>
            </p:cNvPr>
            <p:cNvSpPr txBox="1"/>
            <p:nvPr/>
          </p:nvSpPr>
          <p:spPr>
            <a:xfrm>
              <a:off x="3270221" y="5393138"/>
              <a:ext cx="463461" cy="261348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/>
                <a:t>*</a:t>
              </a:r>
            </a:p>
          </p:txBody>
        </p: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F2EE9357-F323-CB42-A4BC-58C05A86FB4D}"/>
              </a:ext>
            </a:extLst>
          </p:cNvPr>
          <p:cNvGrpSpPr/>
          <p:nvPr/>
        </p:nvGrpSpPr>
        <p:grpSpPr>
          <a:xfrm>
            <a:off x="1998216" y="6675204"/>
            <a:ext cx="2182331" cy="1830037"/>
            <a:chOff x="1998216" y="6646589"/>
            <a:chExt cx="2182331" cy="1830037"/>
          </a:xfrm>
        </p:grpSpPr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13ACFE3E-5EB8-B34B-A46A-D35D520DB933}"/>
                </a:ext>
              </a:extLst>
            </p:cNvPr>
            <p:cNvSpPr txBox="1"/>
            <p:nvPr/>
          </p:nvSpPr>
          <p:spPr>
            <a:xfrm rot="19500000">
              <a:off x="1998216" y="8230405"/>
              <a:ext cx="12621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BCG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682284F8-F29C-6142-B384-834C4ECEAEEE}"/>
                </a:ext>
              </a:extLst>
            </p:cNvPr>
            <p:cNvSpPr txBox="1"/>
            <p:nvPr/>
          </p:nvSpPr>
          <p:spPr>
            <a:xfrm rot="19500000">
              <a:off x="2438962" y="8215967"/>
              <a:ext cx="12621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gp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92B9CB11-921F-A345-8880-BDF6CB389544}"/>
                </a:ext>
              </a:extLst>
            </p:cNvPr>
            <p:cNvSpPr txBox="1"/>
            <p:nvPr/>
          </p:nvSpPr>
          <p:spPr>
            <a:xfrm rot="19500000">
              <a:off x="2918405" y="8214472"/>
              <a:ext cx="12621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199a-3p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ABFEEF34-C842-A642-BA4E-0E91BF717419}"/>
                </a:ext>
              </a:extLst>
            </p:cNvPr>
            <p:cNvSpPr/>
            <p:nvPr/>
          </p:nvSpPr>
          <p:spPr>
            <a:xfrm rot="16200000">
              <a:off x="1581857" y="7386856"/>
              <a:ext cx="172675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700" b="0" i="0" u="none" strike="noStrike" kern="1200" baseline="0">
                  <a:solidFill>
                    <a:prstClr val="black"/>
                  </a:solidFill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defRPr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Expression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FE973FC1-CBD6-7149-9DC8-FB2F7EBBF1BF}"/>
                </a:ext>
              </a:extLst>
            </p:cNvPr>
            <p:cNvSpPr txBox="1"/>
            <p:nvPr/>
          </p:nvSpPr>
          <p:spPr>
            <a:xfrm>
              <a:off x="2794475" y="7086633"/>
              <a:ext cx="115240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2 mg/kg Paclitaxel</a:t>
              </a:r>
              <a:endParaRPr 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TextBox 6">
              <a:extLst>
                <a:ext uri="{FF2B5EF4-FFF2-40B4-BE49-F238E27FC236}">
                  <a16:creationId xmlns:a16="http://schemas.microsoft.com/office/drawing/2014/main" id="{C7C3AB13-008D-854E-8757-DB3C5131D2C7}"/>
                </a:ext>
              </a:extLst>
            </p:cNvPr>
            <p:cNvSpPr txBox="1"/>
            <p:nvPr/>
          </p:nvSpPr>
          <p:spPr>
            <a:xfrm>
              <a:off x="3353746" y="7496840"/>
              <a:ext cx="463461" cy="261348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/>
                <a:t>*</a:t>
              </a:r>
            </a:p>
          </p:txBody>
        </p:sp>
      </p:grpSp>
      <p:sp>
        <p:nvSpPr>
          <p:cNvPr id="183" name="TextBox 182">
            <a:extLst>
              <a:ext uri="{FF2B5EF4-FFF2-40B4-BE49-F238E27FC236}">
                <a16:creationId xmlns:a16="http://schemas.microsoft.com/office/drawing/2014/main" id="{26EBBE7C-F759-0441-9421-301B46C1B007}"/>
              </a:ext>
            </a:extLst>
          </p:cNvPr>
          <p:cNvSpPr txBox="1"/>
          <p:nvPr/>
        </p:nvSpPr>
        <p:spPr>
          <a:xfrm>
            <a:off x="25355" y="25759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B1FA8067-A57F-EB4B-8B39-7BACD786D9D9}"/>
              </a:ext>
            </a:extLst>
          </p:cNvPr>
          <p:cNvSpPr txBox="1"/>
          <p:nvPr/>
        </p:nvSpPr>
        <p:spPr>
          <a:xfrm>
            <a:off x="1946899" y="25759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D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89B3CA54-AB10-4741-AA3A-0C99089A2A4C}"/>
              </a:ext>
            </a:extLst>
          </p:cNvPr>
          <p:cNvSpPr txBox="1"/>
          <p:nvPr/>
        </p:nvSpPr>
        <p:spPr>
          <a:xfrm>
            <a:off x="2659543" y="2419690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2C7142BB-BCDB-F643-9DF7-B3A9E9BD8F24}"/>
              </a:ext>
            </a:extLst>
          </p:cNvPr>
          <p:cNvSpPr txBox="1"/>
          <p:nvPr/>
        </p:nvSpPr>
        <p:spPr>
          <a:xfrm>
            <a:off x="2833238" y="3272701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S miRNA OE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9734E495-7C98-9643-AF67-41AF26E591EC}"/>
              </a:ext>
            </a:extLst>
          </p:cNvPr>
          <p:cNvSpPr txBox="1"/>
          <p:nvPr/>
        </p:nvSpPr>
        <p:spPr>
          <a:xfrm>
            <a:off x="2773926" y="4206314"/>
            <a:ext cx="1143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iR-199a-3p OE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A68FE9EE-AC86-EB4B-BD48-722CC586C4BE}"/>
              </a:ext>
            </a:extLst>
          </p:cNvPr>
          <p:cNvSpPr txBox="1"/>
          <p:nvPr/>
        </p:nvSpPr>
        <p:spPr>
          <a:xfrm>
            <a:off x="3774705" y="2426897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5CE0F69A-2D3B-E545-AA59-AC63AB84CA07}"/>
              </a:ext>
            </a:extLst>
          </p:cNvPr>
          <p:cNvSpPr txBox="1"/>
          <p:nvPr/>
        </p:nvSpPr>
        <p:spPr>
          <a:xfrm>
            <a:off x="2659543" y="3391194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8A36398E-44D7-934E-9787-CFD738EDCFD3}"/>
              </a:ext>
            </a:extLst>
          </p:cNvPr>
          <p:cNvSpPr txBox="1"/>
          <p:nvPr/>
        </p:nvSpPr>
        <p:spPr>
          <a:xfrm>
            <a:off x="3774705" y="3399036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</a:p>
        </p:txBody>
      </p:sp>
      <p:pic>
        <p:nvPicPr>
          <p:cNvPr id="140" name="Picture 139" descr="A close-up of a flower&#10;&#10;Description automatically generated with medium confidence">
            <a:extLst>
              <a:ext uri="{FF2B5EF4-FFF2-40B4-BE49-F238E27FC236}">
                <a16:creationId xmlns:a16="http://schemas.microsoft.com/office/drawing/2014/main" id="{7DD343F2-6C18-4749-83B4-4DD847792B32}"/>
              </a:ext>
            </a:extLst>
          </p:cNvPr>
          <p:cNvPicPr>
            <a:picLocks noChangeAspect="1"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12747" y="2625070"/>
            <a:ext cx="1044971" cy="694944"/>
          </a:xfrm>
          <a:prstGeom prst="rect">
            <a:avLst/>
          </a:prstGeom>
        </p:spPr>
      </p:pic>
      <p:pic>
        <p:nvPicPr>
          <p:cNvPr id="141" name="Picture 140" descr="A close-up of a purple powdery substance&#10;&#10;Description automatically generated with low confidence">
            <a:extLst>
              <a:ext uri="{FF2B5EF4-FFF2-40B4-BE49-F238E27FC236}">
                <a16:creationId xmlns:a16="http://schemas.microsoft.com/office/drawing/2014/main" id="{8DFE26F1-C18A-944B-8AA9-99228E51ACE8}"/>
              </a:ext>
            </a:extLst>
          </p:cNvPr>
          <p:cNvPicPr>
            <a:picLocks noChangeAspect="1"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47947" y="2625059"/>
            <a:ext cx="1044971" cy="694944"/>
          </a:xfrm>
          <a:prstGeom prst="rect">
            <a:avLst/>
          </a:prstGeom>
        </p:spPr>
      </p:pic>
      <p:pic>
        <p:nvPicPr>
          <p:cNvPr id="142" name="Picture 141" descr="Background pattern&#10;&#10;Description automatically generated">
            <a:extLst>
              <a:ext uri="{FF2B5EF4-FFF2-40B4-BE49-F238E27FC236}">
                <a16:creationId xmlns:a16="http://schemas.microsoft.com/office/drawing/2014/main" id="{64612122-C938-5348-A7DF-9835F5EA9ADB}"/>
              </a:ext>
            </a:extLst>
          </p:cNvPr>
          <p:cNvPicPr>
            <a:picLocks noChangeAspect="1"/>
          </p:cNvPicPr>
          <p:nvPr/>
        </p:nvPicPr>
        <p:blipFill>
          <a:blip r:embed="rId2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12747" y="3559586"/>
            <a:ext cx="1044971" cy="694944"/>
          </a:xfrm>
          <a:prstGeom prst="rect">
            <a:avLst/>
          </a:prstGeom>
        </p:spPr>
      </p:pic>
      <p:pic>
        <p:nvPicPr>
          <p:cNvPr id="143" name="Picture 142">
            <a:extLst>
              <a:ext uri="{FF2B5EF4-FFF2-40B4-BE49-F238E27FC236}">
                <a16:creationId xmlns:a16="http://schemas.microsoft.com/office/drawing/2014/main" id="{52732F5C-6E10-AD45-AAD3-EBDACA58BD03}"/>
              </a:ext>
            </a:extLst>
          </p:cNvPr>
          <p:cNvPicPr>
            <a:picLocks noChangeAspect="1"/>
          </p:cNvPicPr>
          <p:nvPr/>
        </p:nvPicPr>
        <p:blipFill>
          <a:blip r:embed="rId2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47947" y="3559586"/>
            <a:ext cx="1044971" cy="694944"/>
          </a:xfrm>
          <a:prstGeom prst="rect">
            <a:avLst/>
          </a:prstGeom>
        </p:spPr>
      </p:pic>
      <p:grpSp>
        <p:nvGrpSpPr>
          <p:cNvPr id="43" name="Group 42">
            <a:extLst>
              <a:ext uri="{FF2B5EF4-FFF2-40B4-BE49-F238E27FC236}">
                <a16:creationId xmlns:a16="http://schemas.microsoft.com/office/drawing/2014/main" id="{0F76F491-B9DD-8C4C-A5A3-16C4F2CEDACF}"/>
              </a:ext>
            </a:extLst>
          </p:cNvPr>
          <p:cNvGrpSpPr/>
          <p:nvPr/>
        </p:nvGrpSpPr>
        <p:grpSpPr>
          <a:xfrm>
            <a:off x="4341559" y="-7368"/>
            <a:ext cx="2291581" cy="1863195"/>
            <a:chOff x="4341559" y="-7368"/>
            <a:chExt cx="2291581" cy="1863195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E53A25AA-0431-9444-8773-CAF2E761F18C}"/>
                </a:ext>
              </a:extLst>
            </p:cNvPr>
            <p:cNvGrpSpPr/>
            <p:nvPr/>
          </p:nvGrpSpPr>
          <p:grpSpPr>
            <a:xfrm>
              <a:off x="4341559" y="-7368"/>
              <a:ext cx="2291581" cy="1863195"/>
              <a:chOff x="126113" y="1599139"/>
              <a:chExt cx="2291581" cy="1863195"/>
            </a:xfrm>
          </p:grpSpPr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BE9F96FB-A6C4-9F4C-8F10-D375F6656123}"/>
                  </a:ext>
                </a:extLst>
              </p:cNvPr>
              <p:cNvGrpSpPr/>
              <p:nvPr/>
            </p:nvGrpSpPr>
            <p:grpSpPr>
              <a:xfrm>
                <a:off x="126113" y="1599139"/>
                <a:ext cx="2187004" cy="1863195"/>
                <a:chOff x="126113" y="1722508"/>
                <a:chExt cx="2187004" cy="1863195"/>
              </a:xfrm>
            </p:grpSpPr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94F1CC1C-6A36-0D45-9347-D0F13F38B765}"/>
                    </a:ext>
                  </a:extLst>
                </p:cNvPr>
                <p:cNvSpPr/>
                <p:nvPr/>
              </p:nvSpPr>
              <p:spPr>
                <a:xfrm rot="16200000">
                  <a:off x="-188527" y="2462775"/>
                  <a:ext cx="1726756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>
                    <a:defRPr sz="700" b="0" i="0" u="none" strike="noStrike" kern="1200" baseline="0">
                      <a:solidFill>
                        <a:prstClr val="black"/>
                      </a:solidFill>
                      <a:latin typeface="Arial Unicode MS" panose="020B0604020202020204" pitchFamily="34" charset="-120"/>
                      <a:ea typeface="Arial Unicode MS" panose="020B0604020202020204" pitchFamily="34" charset="-120"/>
                      <a:cs typeface="Arial Unicode MS" panose="020B0604020202020204" pitchFamily="34" charset="-120"/>
                    </a:defRPr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mRNA Expression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4531F92B-000F-5E49-AB96-131F35C953AE}"/>
                    </a:ext>
                  </a:extLst>
                </p:cNvPr>
                <p:cNvSpPr txBox="1"/>
                <p:nvPr/>
              </p:nvSpPr>
              <p:spPr>
                <a:xfrm rot="19500000">
                  <a:off x="126113" y="3339482"/>
                  <a:ext cx="12621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BCG2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5DB5248C-9FC8-A441-944F-540A5671F69D}"/>
                    </a:ext>
                  </a:extLst>
                </p:cNvPr>
                <p:cNvSpPr txBox="1"/>
                <p:nvPr/>
              </p:nvSpPr>
              <p:spPr>
                <a:xfrm rot="19500000">
                  <a:off x="580793" y="3327660"/>
                  <a:ext cx="12621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</a:t>
                  </a:r>
                  <a:r>
                    <a:rPr lang="en-US" altLang="zh-CN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p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5F7C8DA2-BCED-5F49-9B3D-A380B45281BB}"/>
                    </a:ext>
                  </a:extLst>
                </p:cNvPr>
                <p:cNvSpPr txBox="1"/>
                <p:nvPr/>
              </p:nvSpPr>
              <p:spPr>
                <a:xfrm rot="19500000">
                  <a:off x="1050975" y="3323549"/>
                  <a:ext cx="12621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199a-3p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3" name="TextBox 6">
                <a:extLst>
                  <a:ext uri="{FF2B5EF4-FFF2-40B4-BE49-F238E27FC236}">
                    <a16:creationId xmlns:a16="http://schemas.microsoft.com/office/drawing/2014/main" id="{30E9C3C8-C569-E649-A237-A89C3CDE7BBC}"/>
                  </a:ext>
                </a:extLst>
              </p:cNvPr>
              <p:cNvSpPr txBox="1"/>
              <p:nvPr/>
            </p:nvSpPr>
            <p:spPr>
              <a:xfrm>
                <a:off x="1954233" y="1918373"/>
                <a:ext cx="463461" cy="26134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dirty="0"/>
                  <a:t>***</a:t>
                </a:r>
              </a:p>
            </p:txBody>
          </p:sp>
          <p:sp>
            <p:nvSpPr>
              <p:cNvPr id="157" name="TextBox 6">
                <a:extLst>
                  <a:ext uri="{FF2B5EF4-FFF2-40B4-BE49-F238E27FC236}">
                    <a16:creationId xmlns:a16="http://schemas.microsoft.com/office/drawing/2014/main" id="{F643870E-ABA1-344C-BF9C-683B7D468315}"/>
                  </a:ext>
                </a:extLst>
              </p:cNvPr>
              <p:cNvSpPr txBox="1"/>
              <p:nvPr/>
            </p:nvSpPr>
            <p:spPr>
              <a:xfrm>
                <a:off x="1488619" y="2707488"/>
                <a:ext cx="463461" cy="26134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dirty="0"/>
                  <a:t>*</a:t>
                </a:r>
              </a:p>
            </p:txBody>
          </p:sp>
          <p:sp>
            <p:nvSpPr>
              <p:cNvPr id="180" name="TextBox 6">
                <a:extLst>
                  <a:ext uri="{FF2B5EF4-FFF2-40B4-BE49-F238E27FC236}">
                    <a16:creationId xmlns:a16="http://schemas.microsoft.com/office/drawing/2014/main" id="{5A87A1F0-9E60-584F-B9A4-DE284EBFC9DE}"/>
                  </a:ext>
                </a:extLst>
              </p:cNvPr>
              <p:cNvSpPr txBox="1"/>
              <p:nvPr/>
            </p:nvSpPr>
            <p:spPr>
              <a:xfrm>
                <a:off x="1027462" y="2621258"/>
                <a:ext cx="463461" cy="26134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dirty="0"/>
                  <a:t>*</a:t>
                </a:r>
              </a:p>
            </p:txBody>
          </p:sp>
        </p:grp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8B8943F-2457-0349-9AAE-A71C3CB9ED74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946431" y="6417"/>
              <a:ext cx="1651000" cy="1447800"/>
            </a:xfrm>
            <a:prstGeom prst="rect">
              <a:avLst/>
            </a:prstGeom>
          </p:spPr>
        </p:pic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BF05D685-7A93-6745-87CF-61E2C165B9E6}"/>
              </a:ext>
            </a:extLst>
          </p:cNvPr>
          <p:cNvGrpSpPr/>
          <p:nvPr/>
        </p:nvGrpSpPr>
        <p:grpSpPr>
          <a:xfrm>
            <a:off x="11158" y="6659771"/>
            <a:ext cx="2269640" cy="1837003"/>
            <a:chOff x="11158" y="7055699"/>
            <a:chExt cx="2269640" cy="1837003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500FD911-B6AA-FC47-974D-DF9A9E37316A}"/>
                </a:ext>
              </a:extLst>
            </p:cNvPr>
            <p:cNvGrpSpPr/>
            <p:nvPr/>
          </p:nvGrpSpPr>
          <p:grpSpPr>
            <a:xfrm>
              <a:off x="11158" y="7067478"/>
              <a:ext cx="2269640" cy="1825224"/>
              <a:chOff x="11158" y="6642935"/>
              <a:chExt cx="2269640" cy="1825224"/>
            </a:xfrm>
          </p:grpSpPr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CA0A9DEF-08B0-E449-B6B4-182028BD8983}"/>
                  </a:ext>
                </a:extLst>
              </p:cNvPr>
              <p:cNvSpPr txBox="1"/>
              <p:nvPr/>
            </p:nvSpPr>
            <p:spPr>
              <a:xfrm rot="19500000">
                <a:off x="11158" y="8221938"/>
                <a:ext cx="12621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BCG2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8A8529CF-1C1E-1D4C-8A2A-CBF6DFF60F86}"/>
                  </a:ext>
                </a:extLst>
              </p:cNvPr>
              <p:cNvGrpSpPr/>
              <p:nvPr/>
            </p:nvGrpSpPr>
            <p:grpSpPr>
              <a:xfrm>
                <a:off x="447590" y="6642935"/>
                <a:ext cx="1833208" cy="1814901"/>
                <a:chOff x="447590" y="6642935"/>
                <a:chExt cx="1833208" cy="1814901"/>
              </a:xfrm>
            </p:grpSpPr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196F3D0C-848C-FA4B-9968-6D4BEDCA96DE}"/>
                    </a:ext>
                  </a:extLst>
                </p:cNvPr>
                <p:cNvSpPr txBox="1"/>
                <p:nvPr/>
              </p:nvSpPr>
              <p:spPr>
                <a:xfrm rot="19500000">
                  <a:off x="447590" y="8205109"/>
                  <a:ext cx="12621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</a:t>
                  </a:r>
                  <a:r>
                    <a:rPr lang="en-US" altLang="zh-CN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p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D2ECED82-0798-F44C-8A94-03823A1EB63B}"/>
                    </a:ext>
                  </a:extLst>
                </p:cNvPr>
                <p:cNvSpPr txBox="1"/>
                <p:nvPr/>
              </p:nvSpPr>
              <p:spPr>
                <a:xfrm rot="19500000">
                  <a:off x="911050" y="8211615"/>
                  <a:ext cx="12621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199a-3p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Rectangle 106">
                  <a:extLst>
                    <a:ext uri="{FF2B5EF4-FFF2-40B4-BE49-F238E27FC236}">
                      <a16:creationId xmlns:a16="http://schemas.microsoft.com/office/drawing/2014/main" id="{FBAE7758-C2B4-8643-A0D1-9EED44A02790}"/>
                    </a:ext>
                  </a:extLst>
                </p:cNvPr>
                <p:cNvSpPr/>
                <p:nvPr/>
              </p:nvSpPr>
              <p:spPr>
                <a:xfrm rot="16200000">
                  <a:off x="-274066" y="7383202"/>
                  <a:ext cx="1726756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>
                    <a:defRPr sz="700" b="0" i="0" u="none" strike="noStrike" kern="1200" baseline="0">
                      <a:solidFill>
                        <a:prstClr val="black"/>
                      </a:solidFill>
                      <a:latin typeface="Arial Unicode MS" panose="020B0604020202020204" pitchFamily="34" charset="-120"/>
                      <a:ea typeface="Arial Unicode MS" panose="020B0604020202020204" pitchFamily="34" charset="-120"/>
                      <a:cs typeface="Arial Unicode MS" panose="020B0604020202020204" pitchFamily="34" charset="-120"/>
                    </a:defRPr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mRNA Expression</a:t>
                  </a:r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7B5B1918-47C0-3949-AFB6-D8FC2519E022}"/>
                    </a:ext>
                  </a:extLst>
                </p:cNvPr>
                <p:cNvSpPr txBox="1"/>
                <p:nvPr/>
              </p:nvSpPr>
              <p:spPr>
                <a:xfrm>
                  <a:off x="889143" y="7035382"/>
                  <a:ext cx="115240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 mg/kg Cisplatin</a:t>
                  </a:r>
                  <a:endParaRPr lang="en-US" sz="9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TextBox 6">
                  <a:extLst>
                    <a:ext uri="{FF2B5EF4-FFF2-40B4-BE49-F238E27FC236}">
                      <a16:creationId xmlns:a16="http://schemas.microsoft.com/office/drawing/2014/main" id="{CCDE5A78-B795-DA4A-A065-5AF838425EEF}"/>
                    </a:ext>
                  </a:extLst>
                </p:cNvPr>
                <p:cNvSpPr txBox="1"/>
                <p:nvPr/>
              </p:nvSpPr>
              <p:spPr>
                <a:xfrm>
                  <a:off x="898358" y="7586722"/>
                  <a:ext cx="463461" cy="261348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dirty="0"/>
                    <a:t>*</a:t>
                  </a:r>
                </a:p>
              </p:txBody>
            </p:sp>
            <p:sp>
              <p:nvSpPr>
                <p:cNvPr id="156" name="TextBox 6">
                  <a:extLst>
                    <a:ext uri="{FF2B5EF4-FFF2-40B4-BE49-F238E27FC236}">
                      <a16:creationId xmlns:a16="http://schemas.microsoft.com/office/drawing/2014/main" id="{062E2E8F-5395-1C41-93CC-3085BF3F756B}"/>
                    </a:ext>
                  </a:extLst>
                </p:cNvPr>
                <p:cNvSpPr txBox="1"/>
                <p:nvPr/>
              </p:nvSpPr>
              <p:spPr>
                <a:xfrm>
                  <a:off x="1817337" y="6958282"/>
                  <a:ext cx="463461" cy="261348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dirty="0"/>
                    <a:t>***</a:t>
                  </a:r>
                </a:p>
              </p:txBody>
            </p:sp>
            <p:sp>
              <p:nvSpPr>
                <p:cNvPr id="181" name="TextBox 6">
                  <a:extLst>
                    <a:ext uri="{FF2B5EF4-FFF2-40B4-BE49-F238E27FC236}">
                      <a16:creationId xmlns:a16="http://schemas.microsoft.com/office/drawing/2014/main" id="{695E0B5B-0F53-B649-BE51-239DB3C5E75E}"/>
                    </a:ext>
                  </a:extLst>
                </p:cNvPr>
                <p:cNvSpPr txBox="1"/>
                <p:nvPr/>
              </p:nvSpPr>
              <p:spPr>
                <a:xfrm>
                  <a:off x="1360248" y="7594841"/>
                  <a:ext cx="463461" cy="261348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dirty="0"/>
                    <a:t>*</a:t>
                  </a:r>
                </a:p>
              </p:txBody>
            </p:sp>
          </p:grpSp>
        </p:grp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4BCB7726-E6DB-EA44-8E02-1A12B35E58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600746" y="7055699"/>
              <a:ext cx="1651000" cy="1422400"/>
            </a:xfrm>
            <a:prstGeom prst="rect">
              <a:avLst/>
            </a:prstGeom>
          </p:spPr>
        </p:pic>
      </p:grpSp>
      <p:sp>
        <p:nvSpPr>
          <p:cNvPr id="160" name="TextBox 6">
            <a:extLst>
              <a:ext uri="{FF2B5EF4-FFF2-40B4-BE49-F238E27FC236}">
                <a16:creationId xmlns:a16="http://schemas.microsoft.com/office/drawing/2014/main" id="{1F953F24-1350-B641-B922-6F89D43B2EB1}"/>
              </a:ext>
            </a:extLst>
          </p:cNvPr>
          <p:cNvSpPr txBox="1"/>
          <p:nvPr/>
        </p:nvSpPr>
        <p:spPr>
          <a:xfrm>
            <a:off x="3812038" y="7049361"/>
            <a:ext cx="463461" cy="261348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/>
              <a:t>**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1ABE177D-AEAD-4241-AB22-A952B8104CDE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2493887" y="6698397"/>
            <a:ext cx="1752600" cy="1422400"/>
          </a:xfrm>
          <a:prstGeom prst="rect">
            <a:avLst/>
          </a:prstGeom>
        </p:spPr>
      </p:pic>
      <p:grpSp>
        <p:nvGrpSpPr>
          <p:cNvPr id="132" name="Group 131">
            <a:extLst>
              <a:ext uri="{FF2B5EF4-FFF2-40B4-BE49-F238E27FC236}">
                <a16:creationId xmlns:a16="http://schemas.microsoft.com/office/drawing/2014/main" id="{036A93BF-76C1-EB8B-A5FB-35B2462750CC}"/>
              </a:ext>
            </a:extLst>
          </p:cNvPr>
          <p:cNvGrpSpPr/>
          <p:nvPr/>
        </p:nvGrpSpPr>
        <p:grpSpPr>
          <a:xfrm>
            <a:off x="1353070" y="3281734"/>
            <a:ext cx="152400" cy="27432"/>
            <a:chOff x="6455045" y="9234487"/>
            <a:chExt cx="152400" cy="27432"/>
          </a:xfrm>
        </p:grpSpPr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B125831B-6E0A-67CE-E96D-59FC0F523273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A7BBFFF2-254B-BDD8-775A-531AE8D13A2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CDAD317A-77B3-8576-3FFB-D91AA8C3952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6" name="Group 135">
            <a:extLst>
              <a:ext uri="{FF2B5EF4-FFF2-40B4-BE49-F238E27FC236}">
                <a16:creationId xmlns:a16="http://schemas.microsoft.com/office/drawing/2014/main" id="{CE6E151C-2E5E-9238-780D-7B9411E21163}"/>
              </a:ext>
            </a:extLst>
          </p:cNvPr>
          <p:cNvGrpSpPr/>
          <p:nvPr/>
        </p:nvGrpSpPr>
        <p:grpSpPr>
          <a:xfrm>
            <a:off x="1353070" y="4205429"/>
            <a:ext cx="152400" cy="27432"/>
            <a:chOff x="6455045" y="9234487"/>
            <a:chExt cx="152400" cy="27432"/>
          </a:xfrm>
        </p:grpSpPr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AD2C1865-FCDB-A865-7070-6965880EEDF5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4DB5F171-4ADE-7690-1D1B-E71F8223844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4ED179C0-C14D-E32E-5219-A54EA8C2210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4" name="Group 143">
            <a:extLst>
              <a:ext uri="{FF2B5EF4-FFF2-40B4-BE49-F238E27FC236}">
                <a16:creationId xmlns:a16="http://schemas.microsoft.com/office/drawing/2014/main" id="{D77FA68A-0433-2B5F-ADA7-A6388C56E133}"/>
              </a:ext>
            </a:extLst>
          </p:cNvPr>
          <p:cNvGrpSpPr/>
          <p:nvPr/>
        </p:nvGrpSpPr>
        <p:grpSpPr>
          <a:xfrm>
            <a:off x="3157555" y="3275487"/>
            <a:ext cx="152400" cy="27432"/>
            <a:chOff x="6455045" y="9234487"/>
            <a:chExt cx="152400" cy="27432"/>
          </a:xfrm>
        </p:grpSpPr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4B54DCC2-1421-2AC3-D5B5-2CC3A82A1E14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35CC2D1E-763C-E39A-51CC-94A88F5A6F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E1058ACA-1F74-FA9F-68F6-5403288EC3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2" name="Group 151">
            <a:extLst>
              <a:ext uri="{FF2B5EF4-FFF2-40B4-BE49-F238E27FC236}">
                <a16:creationId xmlns:a16="http://schemas.microsoft.com/office/drawing/2014/main" id="{FAADCD1A-0FE1-5E3D-15C9-B8BD90D09ACE}"/>
              </a:ext>
            </a:extLst>
          </p:cNvPr>
          <p:cNvGrpSpPr/>
          <p:nvPr/>
        </p:nvGrpSpPr>
        <p:grpSpPr>
          <a:xfrm>
            <a:off x="4309018" y="3275020"/>
            <a:ext cx="152400" cy="27432"/>
            <a:chOff x="6455045" y="9234487"/>
            <a:chExt cx="152400" cy="27432"/>
          </a:xfrm>
        </p:grpSpPr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id="{D79D38F8-575F-CCA2-6567-049B8AE2DDA3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>
              <a:extLst>
                <a:ext uri="{FF2B5EF4-FFF2-40B4-BE49-F238E27FC236}">
                  <a16:creationId xmlns:a16="http://schemas.microsoft.com/office/drawing/2014/main" id="{AFDC840F-B55F-4061-D32E-26EE90EB6A4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>
              <a:extLst>
                <a:ext uri="{FF2B5EF4-FFF2-40B4-BE49-F238E27FC236}">
                  <a16:creationId xmlns:a16="http://schemas.microsoft.com/office/drawing/2014/main" id="{5F220FD8-D20A-9061-A5B7-99C88EBE44E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3" name="Group 162">
            <a:extLst>
              <a:ext uri="{FF2B5EF4-FFF2-40B4-BE49-F238E27FC236}">
                <a16:creationId xmlns:a16="http://schemas.microsoft.com/office/drawing/2014/main" id="{1361A2D9-B91F-32C3-D612-CFAA9A98D164}"/>
              </a:ext>
            </a:extLst>
          </p:cNvPr>
          <p:cNvGrpSpPr/>
          <p:nvPr/>
        </p:nvGrpSpPr>
        <p:grpSpPr>
          <a:xfrm>
            <a:off x="3177288" y="4210018"/>
            <a:ext cx="152400" cy="27432"/>
            <a:chOff x="6455045" y="9234487"/>
            <a:chExt cx="152400" cy="27432"/>
          </a:xfrm>
        </p:grpSpPr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2E5D60FD-D297-F695-6FD8-72ED391E934C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>
              <a:extLst>
                <a:ext uri="{FF2B5EF4-FFF2-40B4-BE49-F238E27FC236}">
                  <a16:creationId xmlns:a16="http://schemas.microsoft.com/office/drawing/2014/main" id="{58E403ED-46F4-AAF5-1D3B-6B4A2904C9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CE9EE75E-EC1A-CBD3-AB04-BDD6D543494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1" name="Group 170">
            <a:extLst>
              <a:ext uri="{FF2B5EF4-FFF2-40B4-BE49-F238E27FC236}">
                <a16:creationId xmlns:a16="http://schemas.microsoft.com/office/drawing/2014/main" id="{D0B59C7E-8A2F-616B-3991-0699A2E15A7B}"/>
              </a:ext>
            </a:extLst>
          </p:cNvPr>
          <p:cNvGrpSpPr/>
          <p:nvPr/>
        </p:nvGrpSpPr>
        <p:grpSpPr>
          <a:xfrm>
            <a:off x="4313885" y="4209853"/>
            <a:ext cx="152400" cy="27432"/>
            <a:chOff x="6455045" y="9234487"/>
            <a:chExt cx="152400" cy="27432"/>
          </a:xfrm>
        </p:grpSpPr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id="{B836552E-2F02-2C35-574D-7E5055A161D9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id="{79E02FF4-5EDA-3E24-25C2-1F4CCD8F66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34A9CC50-9085-2084-5EC9-AE5CE11075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5" name="Group 174">
            <a:extLst>
              <a:ext uri="{FF2B5EF4-FFF2-40B4-BE49-F238E27FC236}">
                <a16:creationId xmlns:a16="http://schemas.microsoft.com/office/drawing/2014/main" id="{6D4378B1-112F-DF9D-B253-9189962EE2AF}"/>
              </a:ext>
            </a:extLst>
          </p:cNvPr>
          <p:cNvGrpSpPr/>
          <p:nvPr/>
        </p:nvGrpSpPr>
        <p:grpSpPr>
          <a:xfrm>
            <a:off x="6843694" y="8192870"/>
            <a:ext cx="152400" cy="27432"/>
            <a:chOff x="6455045" y="9234487"/>
            <a:chExt cx="152400" cy="27432"/>
          </a:xfrm>
        </p:grpSpPr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13B3D57B-4019-DF64-88AC-8C538A5EF68B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14865858-4184-001E-8B92-38D7F10B5B9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F2D8369B-22D7-BD2B-7321-EEEF9248DA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2" name="Group 191">
            <a:extLst>
              <a:ext uri="{FF2B5EF4-FFF2-40B4-BE49-F238E27FC236}">
                <a16:creationId xmlns:a16="http://schemas.microsoft.com/office/drawing/2014/main" id="{08D574AD-9F1A-26AE-5D42-110A7A7AC8B4}"/>
              </a:ext>
            </a:extLst>
          </p:cNvPr>
          <p:cNvGrpSpPr/>
          <p:nvPr/>
        </p:nvGrpSpPr>
        <p:grpSpPr>
          <a:xfrm>
            <a:off x="5780280" y="8206586"/>
            <a:ext cx="152400" cy="27432"/>
            <a:chOff x="6455045" y="9234487"/>
            <a:chExt cx="152400" cy="27432"/>
          </a:xfrm>
        </p:grpSpPr>
        <p:cxnSp>
          <p:nvCxnSpPr>
            <p:cNvPr id="193" name="Straight Connector 192">
              <a:extLst>
                <a:ext uri="{FF2B5EF4-FFF2-40B4-BE49-F238E27FC236}">
                  <a16:creationId xmlns:a16="http://schemas.microsoft.com/office/drawing/2014/main" id="{CB13266B-886D-96F4-0CDF-C3E0E93D1DCE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56059136-9B1A-E4C8-F858-066AEA28B72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Straight Connector 194">
              <a:extLst>
                <a:ext uri="{FF2B5EF4-FFF2-40B4-BE49-F238E27FC236}">
                  <a16:creationId xmlns:a16="http://schemas.microsoft.com/office/drawing/2014/main" id="{E8BBF121-0C29-A3CC-F759-DF387A52BBB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id="{65BF75B3-4DD7-F5FC-8315-D112FF16EA64}"/>
              </a:ext>
            </a:extLst>
          </p:cNvPr>
          <p:cNvGrpSpPr/>
          <p:nvPr/>
        </p:nvGrpSpPr>
        <p:grpSpPr>
          <a:xfrm>
            <a:off x="6843694" y="7499273"/>
            <a:ext cx="152400" cy="27432"/>
            <a:chOff x="6455045" y="9234487"/>
            <a:chExt cx="152400" cy="27432"/>
          </a:xfrm>
        </p:grpSpPr>
        <p:cxnSp>
          <p:nvCxnSpPr>
            <p:cNvPr id="197" name="Straight Connector 196">
              <a:extLst>
                <a:ext uri="{FF2B5EF4-FFF2-40B4-BE49-F238E27FC236}">
                  <a16:creationId xmlns:a16="http://schemas.microsoft.com/office/drawing/2014/main" id="{DA9D26D4-12BB-80EF-D6F2-569586192C1B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Straight Connector 197">
              <a:extLst>
                <a:ext uri="{FF2B5EF4-FFF2-40B4-BE49-F238E27FC236}">
                  <a16:creationId xmlns:a16="http://schemas.microsoft.com/office/drawing/2014/main" id="{9AA0868A-199C-0583-0CA3-D1A366CCC4E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Straight Connector 198">
              <a:extLst>
                <a:ext uri="{FF2B5EF4-FFF2-40B4-BE49-F238E27FC236}">
                  <a16:creationId xmlns:a16="http://schemas.microsoft.com/office/drawing/2014/main" id="{B941D14B-1482-F1B2-89B5-4A1E4607B4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0" name="Group 199">
            <a:extLst>
              <a:ext uri="{FF2B5EF4-FFF2-40B4-BE49-F238E27FC236}">
                <a16:creationId xmlns:a16="http://schemas.microsoft.com/office/drawing/2014/main" id="{F7F3B1BE-CFBA-9D80-9DD1-3F97A67D0F47}"/>
              </a:ext>
            </a:extLst>
          </p:cNvPr>
          <p:cNvGrpSpPr/>
          <p:nvPr/>
        </p:nvGrpSpPr>
        <p:grpSpPr>
          <a:xfrm>
            <a:off x="5768631" y="7489835"/>
            <a:ext cx="152400" cy="27432"/>
            <a:chOff x="6455045" y="9234487"/>
            <a:chExt cx="152400" cy="27432"/>
          </a:xfrm>
        </p:grpSpPr>
        <p:cxnSp>
          <p:nvCxnSpPr>
            <p:cNvPr id="201" name="Straight Connector 200">
              <a:extLst>
                <a:ext uri="{FF2B5EF4-FFF2-40B4-BE49-F238E27FC236}">
                  <a16:creationId xmlns:a16="http://schemas.microsoft.com/office/drawing/2014/main" id="{35834688-0BB5-0692-F19F-03F434C1B313}"/>
                </a:ext>
              </a:extLst>
            </p:cNvPr>
            <p:cNvCxnSpPr>
              <a:cxnSpLocks/>
            </p:cNvCxnSpPr>
            <p:nvPr/>
          </p:nvCxnSpPr>
          <p:spPr>
            <a:xfrm>
              <a:off x="6458220" y="9248203"/>
              <a:ext cx="1463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>
              <a:extLst>
                <a:ext uri="{FF2B5EF4-FFF2-40B4-BE49-F238E27FC236}">
                  <a16:creationId xmlns:a16="http://schemas.microsoft.com/office/drawing/2014/main" id="{1FBBC7D3-1AAB-A8E9-6485-F75154F049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50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Connector 202">
              <a:extLst>
                <a:ext uri="{FF2B5EF4-FFF2-40B4-BE49-F238E27FC236}">
                  <a16:creationId xmlns:a16="http://schemas.microsoft.com/office/drawing/2014/main" id="{7AF0205D-B819-3155-9B99-91D7A2B9A93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07445" y="9234487"/>
              <a:ext cx="0" cy="274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56543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53</TotalTime>
  <Words>1055</Words>
  <Application>Microsoft Macintosh PowerPoint</Application>
  <PresentationFormat>Custom</PresentationFormat>
  <Paragraphs>291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1259275</dc:creator>
  <cp:lastModifiedBy>h1259275</cp:lastModifiedBy>
  <cp:revision>367</cp:revision>
  <dcterms:created xsi:type="dcterms:W3CDTF">2021-04-21T12:54:15Z</dcterms:created>
  <dcterms:modified xsi:type="dcterms:W3CDTF">2022-05-05T05:46:23Z</dcterms:modified>
</cp:coreProperties>
</file>